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3" d="100"/>
          <a:sy n="123" d="100"/>
        </p:scale>
        <p:origin x="-2160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312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820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762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9220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355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9547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5936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8273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4731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303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2638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AF9B95-818C-6E42-B0C3-8A226AFF382E}" type="datetimeFigureOut">
              <a:rPr kumimoji="1" lang="ja-JP" altLang="en-US" smtClean="0"/>
              <a:t>13/08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317FA-5441-FE43-913E-0C730A47B2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205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Rectangle 492"/>
          <p:cNvSpPr>
            <a:spLocks noChangeArrowheads="1"/>
          </p:cNvSpPr>
          <p:nvPr/>
        </p:nvSpPr>
        <p:spPr bwMode="auto">
          <a:xfrm>
            <a:off x="1562111" y="4203465"/>
            <a:ext cx="29579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Arial"/>
                <a:ea typeface="Arial" charset="0"/>
                <a:cs typeface="Arial"/>
              </a:rPr>
              <a:t>B</a:t>
            </a:r>
          </a:p>
        </p:txBody>
      </p:sp>
      <p:sp>
        <p:nvSpPr>
          <p:cNvPr id="73" name="Rectangle 492"/>
          <p:cNvSpPr>
            <a:spLocks noChangeArrowheads="1"/>
          </p:cNvSpPr>
          <p:nvPr/>
        </p:nvSpPr>
        <p:spPr bwMode="auto">
          <a:xfrm>
            <a:off x="3490937" y="4203463"/>
            <a:ext cx="29579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Arial"/>
                <a:ea typeface="Arial" charset="0"/>
                <a:cs typeface="Arial"/>
              </a:rPr>
              <a:t>C</a:t>
            </a:r>
          </a:p>
        </p:txBody>
      </p:sp>
      <p:grpSp>
        <p:nvGrpSpPr>
          <p:cNvPr id="74" name="Group 72"/>
          <p:cNvGrpSpPr>
            <a:grpSpLocks/>
          </p:cNvGrpSpPr>
          <p:nvPr/>
        </p:nvGrpSpPr>
        <p:grpSpPr bwMode="auto">
          <a:xfrm>
            <a:off x="1556320" y="4552600"/>
            <a:ext cx="1857375" cy="2187576"/>
            <a:chOff x="842" y="1584"/>
            <a:chExt cx="1170" cy="1378"/>
          </a:xfrm>
        </p:grpSpPr>
        <p:grpSp>
          <p:nvGrpSpPr>
            <p:cNvPr id="76" name="Group 70"/>
            <p:cNvGrpSpPr>
              <a:grpSpLocks/>
            </p:cNvGrpSpPr>
            <p:nvPr/>
          </p:nvGrpSpPr>
          <p:grpSpPr bwMode="auto">
            <a:xfrm>
              <a:off x="1227" y="1855"/>
              <a:ext cx="170" cy="921"/>
              <a:chOff x="1227" y="1855"/>
              <a:chExt cx="170" cy="921"/>
            </a:xfrm>
          </p:grpSpPr>
          <p:sp>
            <p:nvSpPr>
              <p:cNvPr id="104" name="Rectangle 8"/>
              <p:cNvSpPr>
                <a:spLocks noChangeArrowheads="1"/>
              </p:cNvSpPr>
              <p:nvPr/>
            </p:nvSpPr>
            <p:spPr bwMode="auto">
              <a:xfrm>
                <a:off x="1227" y="1943"/>
                <a:ext cx="170" cy="83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05" name="Line 9"/>
              <p:cNvSpPr>
                <a:spLocks noChangeShapeType="1"/>
              </p:cNvSpPr>
              <p:nvPr/>
            </p:nvSpPr>
            <p:spPr bwMode="auto">
              <a:xfrm flipV="1">
                <a:off x="1312" y="1855"/>
                <a:ext cx="1" cy="8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06" name="Line 10"/>
              <p:cNvSpPr>
                <a:spLocks noChangeShapeType="1"/>
              </p:cNvSpPr>
              <p:nvPr/>
            </p:nvSpPr>
            <p:spPr bwMode="auto">
              <a:xfrm>
                <a:off x="1292" y="1855"/>
                <a:ext cx="4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07" name="Line 11"/>
              <p:cNvSpPr>
                <a:spLocks noChangeShapeType="1"/>
              </p:cNvSpPr>
              <p:nvPr/>
            </p:nvSpPr>
            <p:spPr bwMode="auto">
              <a:xfrm>
                <a:off x="1312" y="1940"/>
                <a:ext cx="1" cy="84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08" name="Line 12"/>
              <p:cNvSpPr>
                <a:spLocks noChangeShapeType="1"/>
              </p:cNvSpPr>
              <p:nvPr/>
            </p:nvSpPr>
            <p:spPr bwMode="auto">
              <a:xfrm>
                <a:off x="1292" y="2024"/>
                <a:ext cx="40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</p:grpSp>
        <p:grpSp>
          <p:nvGrpSpPr>
            <p:cNvPr id="77" name="Group 13"/>
            <p:cNvGrpSpPr>
              <a:grpSpLocks/>
            </p:cNvGrpSpPr>
            <p:nvPr/>
          </p:nvGrpSpPr>
          <p:grpSpPr bwMode="auto">
            <a:xfrm>
              <a:off x="1489" y="2011"/>
              <a:ext cx="169" cy="765"/>
              <a:chOff x="2053" y="2882"/>
              <a:chExt cx="215" cy="981"/>
            </a:xfrm>
          </p:grpSpPr>
          <p:sp>
            <p:nvSpPr>
              <p:cNvPr id="99" name="Rectangle 14"/>
              <p:cNvSpPr>
                <a:spLocks noChangeArrowheads="1"/>
              </p:cNvSpPr>
              <p:nvPr/>
            </p:nvSpPr>
            <p:spPr bwMode="auto">
              <a:xfrm>
                <a:off x="2053" y="2974"/>
                <a:ext cx="215" cy="88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00" name="Line 15"/>
              <p:cNvSpPr>
                <a:spLocks noChangeShapeType="1"/>
              </p:cNvSpPr>
              <p:nvPr/>
            </p:nvSpPr>
            <p:spPr bwMode="auto">
              <a:xfrm flipV="1">
                <a:off x="2160" y="2882"/>
                <a:ext cx="1" cy="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01" name="Line 16"/>
              <p:cNvSpPr>
                <a:spLocks noChangeShapeType="1"/>
              </p:cNvSpPr>
              <p:nvPr/>
            </p:nvSpPr>
            <p:spPr bwMode="auto">
              <a:xfrm>
                <a:off x="2135" y="2882"/>
                <a:ext cx="52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02" name="Line 17"/>
              <p:cNvSpPr>
                <a:spLocks noChangeShapeType="1"/>
              </p:cNvSpPr>
              <p:nvPr/>
            </p:nvSpPr>
            <p:spPr bwMode="auto">
              <a:xfrm>
                <a:off x="2160" y="2970"/>
                <a:ext cx="1" cy="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03" name="Line 18"/>
              <p:cNvSpPr>
                <a:spLocks noChangeShapeType="1"/>
              </p:cNvSpPr>
              <p:nvPr/>
            </p:nvSpPr>
            <p:spPr bwMode="auto">
              <a:xfrm>
                <a:off x="2135" y="3058"/>
                <a:ext cx="52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</p:grpSp>
        <p:grpSp>
          <p:nvGrpSpPr>
            <p:cNvPr id="78" name="Group 69"/>
            <p:cNvGrpSpPr>
              <a:grpSpLocks/>
            </p:cNvGrpSpPr>
            <p:nvPr/>
          </p:nvGrpSpPr>
          <p:grpSpPr bwMode="auto">
            <a:xfrm>
              <a:off x="1750" y="2139"/>
              <a:ext cx="170" cy="637"/>
              <a:chOff x="1750" y="2139"/>
              <a:chExt cx="170" cy="637"/>
            </a:xfrm>
          </p:grpSpPr>
          <p:sp>
            <p:nvSpPr>
              <p:cNvPr id="94" name="Rectangle 5"/>
              <p:cNvSpPr>
                <a:spLocks noChangeArrowheads="1"/>
              </p:cNvSpPr>
              <p:nvPr/>
            </p:nvSpPr>
            <p:spPr bwMode="auto">
              <a:xfrm>
                <a:off x="1750" y="2192"/>
                <a:ext cx="170" cy="58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95" name="Line 6"/>
              <p:cNvSpPr>
                <a:spLocks noChangeShapeType="1"/>
              </p:cNvSpPr>
              <p:nvPr/>
            </p:nvSpPr>
            <p:spPr bwMode="auto">
              <a:xfrm flipV="1">
                <a:off x="1835" y="2139"/>
                <a:ext cx="1" cy="49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96" name="Line 7"/>
              <p:cNvSpPr>
                <a:spLocks noChangeShapeType="1"/>
              </p:cNvSpPr>
              <p:nvPr/>
            </p:nvSpPr>
            <p:spPr bwMode="auto">
              <a:xfrm>
                <a:off x="1815" y="2139"/>
                <a:ext cx="40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97" name="Line 19"/>
              <p:cNvSpPr>
                <a:spLocks noChangeShapeType="1"/>
              </p:cNvSpPr>
              <p:nvPr/>
            </p:nvSpPr>
            <p:spPr bwMode="auto">
              <a:xfrm>
                <a:off x="1835" y="2188"/>
                <a:ext cx="1" cy="5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98" name="Line 20"/>
              <p:cNvSpPr>
                <a:spLocks noChangeShapeType="1"/>
              </p:cNvSpPr>
              <p:nvPr/>
            </p:nvSpPr>
            <p:spPr bwMode="auto">
              <a:xfrm>
                <a:off x="1815" y="2238"/>
                <a:ext cx="40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</p:grpSp>
        <p:sp>
          <p:nvSpPr>
            <p:cNvPr id="79" name="Freeform 21"/>
            <p:cNvSpPr>
              <a:spLocks/>
            </p:cNvSpPr>
            <p:nvPr/>
          </p:nvSpPr>
          <p:spPr bwMode="auto">
            <a:xfrm>
              <a:off x="1125" y="1607"/>
              <a:ext cx="10" cy="1169"/>
            </a:xfrm>
            <a:custGeom>
              <a:avLst/>
              <a:gdLst>
                <a:gd name="T0" fmla="*/ 0 w 13"/>
                <a:gd name="T1" fmla="*/ 0 h 1498"/>
                <a:gd name="T2" fmla="*/ 0 w 13"/>
                <a:gd name="T3" fmla="*/ 1498 h 1498"/>
                <a:gd name="T4" fmla="*/ 13 w 13"/>
                <a:gd name="T5" fmla="*/ 1498 h 14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1498">
                  <a:moveTo>
                    <a:pt x="0" y="0"/>
                  </a:moveTo>
                  <a:lnTo>
                    <a:pt x="0" y="1498"/>
                  </a:lnTo>
                  <a:lnTo>
                    <a:pt x="13" y="1498"/>
                  </a:lnTo>
                </a:path>
              </a:pathLst>
            </a:custGeom>
            <a:noFill/>
            <a:ln w="12700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80" name="Line 22"/>
            <p:cNvSpPr>
              <a:spLocks noChangeShapeType="1"/>
            </p:cNvSpPr>
            <p:nvPr/>
          </p:nvSpPr>
          <p:spPr bwMode="auto">
            <a:xfrm>
              <a:off x="1125" y="2487"/>
              <a:ext cx="2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81" name="Line 23"/>
            <p:cNvSpPr>
              <a:spLocks noChangeShapeType="1"/>
            </p:cNvSpPr>
            <p:nvPr/>
          </p:nvSpPr>
          <p:spPr bwMode="auto">
            <a:xfrm>
              <a:off x="1125" y="2195"/>
              <a:ext cx="2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82" name="Line 24"/>
            <p:cNvSpPr>
              <a:spLocks noChangeShapeType="1"/>
            </p:cNvSpPr>
            <p:nvPr/>
          </p:nvSpPr>
          <p:spPr bwMode="auto">
            <a:xfrm>
              <a:off x="1125" y="1904"/>
              <a:ext cx="2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83" name="Line 25"/>
            <p:cNvSpPr>
              <a:spLocks noChangeShapeType="1"/>
            </p:cNvSpPr>
            <p:nvPr/>
          </p:nvSpPr>
          <p:spPr bwMode="auto">
            <a:xfrm>
              <a:off x="1125" y="1611"/>
              <a:ext cx="2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84" name="Line 26"/>
            <p:cNvSpPr>
              <a:spLocks noChangeShapeType="1"/>
            </p:cNvSpPr>
            <p:nvPr/>
          </p:nvSpPr>
          <p:spPr bwMode="auto">
            <a:xfrm>
              <a:off x="1125" y="2776"/>
              <a:ext cx="88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85" name="Rectangle 27"/>
            <p:cNvSpPr>
              <a:spLocks noChangeArrowheads="1"/>
            </p:cNvSpPr>
            <p:nvPr/>
          </p:nvSpPr>
          <p:spPr bwMode="auto">
            <a:xfrm>
              <a:off x="1055" y="2753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86" name="Rectangle 28"/>
            <p:cNvSpPr>
              <a:spLocks noChangeArrowheads="1"/>
            </p:cNvSpPr>
            <p:nvPr/>
          </p:nvSpPr>
          <p:spPr bwMode="auto">
            <a:xfrm>
              <a:off x="1006" y="2460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87" name="Rectangle 29"/>
            <p:cNvSpPr>
              <a:spLocks noChangeArrowheads="1"/>
            </p:cNvSpPr>
            <p:nvPr/>
          </p:nvSpPr>
          <p:spPr bwMode="auto">
            <a:xfrm>
              <a:off x="1055" y="2166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88" name="Rectangle 30"/>
            <p:cNvSpPr>
              <a:spLocks noChangeArrowheads="1"/>
            </p:cNvSpPr>
            <p:nvPr/>
          </p:nvSpPr>
          <p:spPr bwMode="auto">
            <a:xfrm>
              <a:off x="1006" y="1878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89" name="Rectangle 31"/>
            <p:cNvSpPr>
              <a:spLocks noChangeArrowheads="1"/>
            </p:cNvSpPr>
            <p:nvPr/>
          </p:nvSpPr>
          <p:spPr bwMode="auto">
            <a:xfrm>
              <a:off x="1055" y="1584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90" name="Rectangle 32"/>
            <p:cNvSpPr>
              <a:spLocks noChangeArrowheads="1"/>
            </p:cNvSpPr>
            <p:nvPr/>
          </p:nvSpPr>
          <p:spPr bwMode="auto">
            <a:xfrm>
              <a:off x="1184" y="2807"/>
              <a:ext cx="26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Foxp3 (-)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91" name="Rectangle 33"/>
            <p:cNvSpPr>
              <a:spLocks noChangeArrowheads="1"/>
            </p:cNvSpPr>
            <p:nvPr/>
          </p:nvSpPr>
          <p:spPr bwMode="auto">
            <a:xfrm>
              <a:off x="1448" y="2807"/>
              <a:ext cx="28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Foxp3 (+)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92" name="Rectangle 34"/>
            <p:cNvSpPr>
              <a:spLocks noChangeArrowheads="1"/>
            </p:cNvSpPr>
            <p:nvPr/>
          </p:nvSpPr>
          <p:spPr bwMode="auto">
            <a:xfrm>
              <a:off x="1774" y="2807"/>
              <a:ext cx="129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HBZ</a:t>
              </a:r>
            </a:p>
            <a:p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CD4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93" name="Rectangle 68"/>
            <p:cNvSpPr>
              <a:spLocks noChangeArrowheads="1"/>
            </p:cNvSpPr>
            <p:nvPr/>
          </p:nvSpPr>
          <p:spPr bwMode="auto">
            <a:xfrm rot="16200000">
              <a:off x="486" y="2088"/>
              <a:ext cx="867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/>
                  <a:cs typeface="Arial"/>
                </a:rPr>
                <a:t>Relative level of expression</a:t>
              </a:r>
            </a:p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/>
                  <a:cs typeface="Arial"/>
                </a:rPr>
                <a:t> (</a:t>
              </a:r>
              <a:r>
                <a:rPr lang="en-US" altLang="ja-JP" sz="800" i="1" dirty="0">
                  <a:solidFill>
                    <a:srgbClr val="000000"/>
                  </a:solidFill>
                  <a:latin typeface="Arial"/>
                  <a:cs typeface="Arial"/>
                </a:rPr>
                <a:t>HBZ/18S </a:t>
              </a:r>
              <a:r>
                <a:rPr lang="en-US" altLang="ja-JP" sz="800" i="1" dirty="0" err="1">
                  <a:solidFill>
                    <a:srgbClr val="000000"/>
                  </a:solidFill>
                  <a:latin typeface="Arial"/>
                  <a:cs typeface="Arial"/>
                </a:rPr>
                <a:t>rRNA</a:t>
              </a:r>
              <a:r>
                <a:rPr lang="en-US" altLang="ja-JP" sz="800" dirty="0">
                  <a:solidFill>
                    <a:srgbClr val="000000"/>
                  </a:solidFill>
                  <a:latin typeface="Arial"/>
                  <a:cs typeface="Arial"/>
                </a:rPr>
                <a:t>)</a:t>
              </a:r>
              <a:endParaRPr lang="en-US" altLang="ja-JP" sz="800" dirty="0">
                <a:latin typeface="Arial"/>
                <a:cs typeface="Arial"/>
              </a:endParaRPr>
            </a:p>
          </p:txBody>
        </p:sp>
      </p:grpSp>
      <p:grpSp>
        <p:nvGrpSpPr>
          <p:cNvPr id="109" name="Group 74"/>
          <p:cNvGrpSpPr>
            <a:grpSpLocks/>
          </p:cNvGrpSpPr>
          <p:nvPr/>
        </p:nvGrpSpPr>
        <p:grpSpPr bwMode="auto">
          <a:xfrm>
            <a:off x="3485133" y="4527203"/>
            <a:ext cx="1878013" cy="2235201"/>
            <a:chOff x="1997" y="1568"/>
            <a:chExt cx="1183" cy="1408"/>
          </a:xfrm>
        </p:grpSpPr>
        <p:grpSp>
          <p:nvGrpSpPr>
            <p:cNvPr id="110" name="Group 36"/>
            <p:cNvGrpSpPr>
              <a:grpSpLocks/>
            </p:cNvGrpSpPr>
            <p:nvPr/>
          </p:nvGrpSpPr>
          <p:grpSpPr bwMode="auto">
            <a:xfrm>
              <a:off x="2380" y="2591"/>
              <a:ext cx="175" cy="199"/>
              <a:chOff x="4707" y="3728"/>
              <a:chExt cx="218" cy="248"/>
            </a:xfrm>
          </p:grpSpPr>
          <p:sp>
            <p:nvSpPr>
              <p:cNvPr id="138" name="Rectangle 37"/>
              <p:cNvSpPr>
                <a:spLocks noChangeArrowheads="1"/>
              </p:cNvSpPr>
              <p:nvPr/>
            </p:nvSpPr>
            <p:spPr bwMode="auto">
              <a:xfrm>
                <a:off x="4707" y="3740"/>
                <a:ext cx="218" cy="23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39" name="Line 38"/>
              <p:cNvSpPr>
                <a:spLocks noChangeShapeType="1"/>
              </p:cNvSpPr>
              <p:nvPr/>
            </p:nvSpPr>
            <p:spPr bwMode="auto">
              <a:xfrm flipV="1">
                <a:off x="4816" y="3728"/>
                <a:ext cx="1" cy="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40" name="Line 39"/>
              <p:cNvSpPr>
                <a:spLocks noChangeShapeType="1"/>
              </p:cNvSpPr>
              <p:nvPr/>
            </p:nvSpPr>
            <p:spPr bwMode="auto">
              <a:xfrm>
                <a:off x="4790" y="3728"/>
                <a:ext cx="52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41" name="Line 40"/>
              <p:cNvSpPr>
                <a:spLocks noChangeShapeType="1"/>
              </p:cNvSpPr>
              <p:nvPr/>
            </p:nvSpPr>
            <p:spPr bwMode="auto">
              <a:xfrm>
                <a:off x="4816" y="3736"/>
                <a:ext cx="1" cy="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42" name="Line 41"/>
              <p:cNvSpPr>
                <a:spLocks noChangeShapeType="1"/>
              </p:cNvSpPr>
              <p:nvPr/>
            </p:nvSpPr>
            <p:spPr bwMode="auto">
              <a:xfrm>
                <a:off x="4790" y="3747"/>
                <a:ext cx="52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</p:grpSp>
        <p:grpSp>
          <p:nvGrpSpPr>
            <p:cNvPr id="111" name="Group 42"/>
            <p:cNvGrpSpPr>
              <a:grpSpLocks/>
            </p:cNvGrpSpPr>
            <p:nvPr/>
          </p:nvGrpSpPr>
          <p:grpSpPr bwMode="auto">
            <a:xfrm>
              <a:off x="2648" y="1718"/>
              <a:ext cx="174" cy="1072"/>
              <a:chOff x="5042" y="2636"/>
              <a:chExt cx="218" cy="1340"/>
            </a:xfrm>
          </p:grpSpPr>
          <p:sp>
            <p:nvSpPr>
              <p:cNvPr id="133" name="Rectangle 43"/>
              <p:cNvSpPr>
                <a:spLocks noChangeArrowheads="1"/>
              </p:cNvSpPr>
              <p:nvPr/>
            </p:nvSpPr>
            <p:spPr bwMode="auto">
              <a:xfrm>
                <a:off x="5042" y="2647"/>
                <a:ext cx="218" cy="132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34" name="Line 44"/>
              <p:cNvSpPr>
                <a:spLocks noChangeShapeType="1"/>
              </p:cNvSpPr>
              <p:nvPr/>
            </p:nvSpPr>
            <p:spPr bwMode="auto">
              <a:xfrm flipV="1">
                <a:off x="5151" y="2636"/>
                <a:ext cx="1" cy="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35" name="Line 45"/>
              <p:cNvSpPr>
                <a:spLocks noChangeShapeType="1"/>
              </p:cNvSpPr>
              <p:nvPr/>
            </p:nvSpPr>
            <p:spPr bwMode="auto">
              <a:xfrm>
                <a:off x="5125" y="2636"/>
                <a:ext cx="5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36" name="Line 46"/>
              <p:cNvSpPr>
                <a:spLocks noChangeShapeType="1"/>
              </p:cNvSpPr>
              <p:nvPr/>
            </p:nvSpPr>
            <p:spPr bwMode="auto">
              <a:xfrm>
                <a:off x="5151" y="2643"/>
                <a:ext cx="1" cy="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37" name="Line 47"/>
              <p:cNvSpPr>
                <a:spLocks noChangeShapeType="1"/>
              </p:cNvSpPr>
              <p:nvPr/>
            </p:nvSpPr>
            <p:spPr bwMode="auto">
              <a:xfrm>
                <a:off x="5125" y="2654"/>
                <a:ext cx="52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</p:grpSp>
        <p:grpSp>
          <p:nvGrpSpPr>
            <p:cNvPr id="112" name="Group 48"/>
            <p:cNvGrpSpPr>
              <a:grpSpLocks/>
            </p:cNvGrpSpPr>
            <p:nvPr/>
          </p:nvGrpSpPr>
          <p:grpSpPr bwMode="auto">
            <a:xfrm>
              <a:off x="2915" y="2711"/>
              <a:ext cx="175" cy="79"/>
              <a:chOff x="5376" y="3878"/>
              <a:chExt cx="218" cy="98"/>
            </a:xfrm>
          </p:grpSpPr>
          <p:sp>
            <p:nvSpPr>
              <p:cNvPr id="128" name="Rectangle 49"/>
              <p:cNvSpPr>
                <a:spLocks noChangeArrowheads="1"/>
              </p:cNvSpPr>
              <p:nvPr/>
            </p:nvSpPr>
            <p:spPr bwMode="auto">
              <a:xfrm>
                <a:off x="5376" y="3901"/>
                <a:ext cx="218" cy="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29" name="Line 50"/>
              <p:cNvSpPr>
                <a:spLocks noChangeShapeType="1"/>
              </p:cNvSpPr>
              <p:nvPr/>
            </p:nvSpPr>
            <p:spPr bwMode="auto">
              <a:xfrm flipV="1">
                <a:off x="5485" y="3878"/>
                <a:ext cx="1" cy="19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30" name="Line 51"/>
              <p:cNvSpPr>
                <a:spLocks noChangeShapeType="1"/>
              </p:cNvSpPr>
              <p:nvPr/>
            </p:nvSpPr>
            <p:spPr bwMode="auto">
              <a:xfrm>
                <a:off x="5460" y="3878"/>
                <a:ext cx="51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31" name="Line 52"/>
              <p:cNvSpPr>
                <a:spLocks noChangeShapeType="1"/>
              </p:cNvSpPr>
              <p:nvPr/>
            </p:nvSpPr>
            <p:spPr bwMode="auto">
              <a:xfrm>
                <a:off x="5485" y="3897"/>
                <a:ext cx="1" cy="19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  <p:sp>
            <p:nvSpPr>
              <p:cNvPr id="132" name="Line 53"/>
              <p:cNvSpPr>
                <a:spLocks noChangeShapeType="1"/>
              </p:cNvSpPr>
              <p:nvPr/>
            </p:nvSpPr>
            <p:spPr bwMode="auto">
              <a:xfrm>
                <a:off x="5460" y="3916"/>
                <a:ext cx="51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/>
                  <a:cs typeface="Arial"/>
                </a:endParaRPr>
              </a:p>
            </p:txBody>
          </p:sp>
        </p:grpSp>
        <p:sp>
          <p:nvSpPr>
            <p:cNvPr id="113" name="Freeform 54"/>
            <p:cNvSpPr>
              <a:spLocks/>
            </p:cNvSpPr>
            <p:nvPr/>
          </p:nvSpPr>
          <p:spPr bwMode="auto">
            <a:xfrm>
              <a:off x="2277" y="1592"/>
              <a:ext cx="10" cy="1198"/>
            </a:xfrm>
            <a:custGeom>
              <a:avLst/>
              <a:gdLst>
                <a:gd name="T0" fmla="*/ 0 w 13"/>
                <a:gd name="T1" fmla="*/ 0 h 1498"/>
                <a:gd name="T2" fmla="*/ 0 w 13"/>
                <a:gd name="T3" fmla="*/ 1498 h 1498"/>
                <a:gd name="T4" fmla="*/ 13 w 13"/>
                <a:gd name="T5" fmla="*/ 1498 h 14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1498">
                  <a:moveTo>
                    <a:pt x="0" y="0"/>
                  </a:moveTo>
                  <a:lnTo>
                    <a:pt x="0" y="1498"/>
                  </a:lnTo>
                  <a:lnTo>
                    <a:pt x="13" y="1498"/>
                  </a:lnTo>
                </a:path>
              </a:pathLst>
            </a:custGeom>
            <a:noFill/>
            <a:ln w="12700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114" name="Line 55"/>
            <p:cNvSpPr>
              <a:spLocks noChangeShapeType="1"/>
            </p:cNvSpPr>
            <p:nvPr/>
          </p:nvSpPr>
          <p:spPr bwMode="auto">
            <a:xfrm>
              <a:off x="2277" y="2494"/>
              <a:ext cx="2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115" name="Line 56"/>
            <p:cNvSpPr>
              <a:spLocks noChangeShapeType="1"/>
            </p:cNvSpPr>
            <p:nvPr/>
          </p:nvSpPr>
          <p:spPr bwMode="auto">
            <a:xfrm>
              <a:off x="2277" y="2195"/>
              <a:ext cx="2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116" name="Line 57"/>
            <p:cNvSpPr>
              <a:spLocks noChangeShapeType="1"/>
            </p:cNvSpPr>
            <p:nvPr/>
          </p:nvSpPr>
          <p:spPr bwMode="auto">
            <a:xfrm>
              <a:off x="2277" y="1896"/>
              <a:ext cx="2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117" name="Line 58"/>
            <p:cNvSpPr>
              <a:spLocks noChangeShapeType="1"/>
            </p:cNvSpPr>
            <p:nvPr/>
          </p:nvSpPr>
          <p:spPr bwMode="auto">
            <a:xfrm>
              <a:off x="2277" y="1596"/>
              <a:ext cx="2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118" name="Line 59"/>
            <p:cNvSpPr>
              <a:spLocks noChangeShapeType="1"/>
            </p:cNvSpPr>
            <p:nvPr/>
          </p:nvSpPr>
          <p:spPr bwMode="auto">
            <a:xfrm>
              <a:off x="2273" y="2791"/>
              <a:ext cx="90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/>
                <a:cs typeface="Arial"/>
              </a:endParaRPr>
            </a:p>
          </p:txBody>
        </p:sp>
        <p:sp>
          <p:nvSpPr>
            <p:cNvPr id="119" name="Rectangle 60"/>
            <p:cNvSpPr>
              <a:spLocks noChangeArrowheads="1"/>
            </p:cNvSpPr>
            <p:nvPr/>
          </p:nvSpPr>
          <p:spPr bwMode="auto">
            <a:xfrm>
              <a:off x="2206" y="2766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120" name="Rectangle 61"/>
            <p:cNvSpPr>
              <a:spLocks noChangeArrowheads="1"/>
            </p:cNvSpPr>
            <p:nvPr/>
          </p:nvSpPr>
          <p:spPr bwMode="auto">
            <a:xfrm>
              <a:off x="2202" y="2466"/>
              <a:ext cx="4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121" name="Rectangle 62"/>
            <p:cNvSpPr>
              <a:spLocks noChangeArrowheads="1"/>
            </p:cNvSpPr>
            <p:nvPr/>
          </p:nvSpPr>
          <p:spPr bwMode="auto">
            <a:xfrm>
              <a:off x="2170" y="2167"/>
              <a:ext cx="7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122" name="Rectangle 63"/>
            <p:cNvSpPr>
              <a:spLocks noChangeArrowheads="1"/>
            </p:cNvSpPr>
            <p:nvPr/>
          </p:nvSpPr>
          <p:spPr bwMode="auto">
            <a:xfrm>
              <a:off x="2169" y="1868"/>
              <a:ext cx="7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15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123" name="Rectangle 64"/>
            <p:cNvSpPr>
              <a:spLocks noChangeArrowheads="1"/>
            </p:cNvSpPr>
            <p:nvPr/>
          </p:nvSpPr>
          <p:spPr bwMode="auto">
            <a:xfrm>
              <a:off x="2170" y="1568"/>
              <a:ext cx="7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124" name="Rectangle 65"/>
            <p:cNvSpPr>
              <a:spLocks noChangeArrowheads="1"/>
            </p:cNvSpPr>
            <p:nvPr/>
          </p:nvSpPr>
          <p:spPr bwMode="auto">
            <a:xfrm>
              <a:off x="2355" y="2821"/>
              <a:ext cx="26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Foxp3 (-)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125" name="Rectangle 66"/>
            <p:cNvSpPr>
              <a:spLocks noChangeArrowheads="1"/>
            </p:cNvSpPr>
            <p:nvPr/>
          </p:nvSpPr>
          <p:spPr bwMode="auto">
            <a:xfrm>
              <a:off x="2614" y="2821"/>
              <a:ext cx="28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latin typeface="Arial"/>
                  <a:cs typeface="Arial"/>
                </a:rPr>
                <a:t>Foxp3 (+)</a:t>
              </a:r>
              <a:endParaRPr lang="en-US" altLang="ja-JP" sz="800" dirty="0">
                <a:latin typeface="Arial"/>
                <a:cs typeface="Arial"/>
              </a:endParaRPr>
            </a:p>
          </p:txBody>
        </p:sp>
        <p:sp>
          <p:nvSpPr>
            <p:cNvPr id="126" name="Rectangle 67"/>
            <p:cNvSpPr>
              <a:spLocks noChangeArrowheads="1"/>
            </p:cNvSpPr>
            <p:nvPr/>
          </p:nvSpPr>
          <p:spPr bwMode="auto">
            <a:xfrm>
              <a:off x="2950" y="2821"/>
              <a:ext cx="129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WT</a:t>
              </a:r>
            </a:p>
            <a:p>
              <a:r>
                <a:rPr lang="en-US" altLang="ja-JP" sz="800">
                  <a:solidFill>
                    <a:srgbClr val="000000"/>
                  </a:solidFill>
                  <a:latin typeface="Arial"/>
                  <a:cs typeface="Arial"/>
                </a:rPr>
                <a:t>CD4</a:t>
              </a:r>
              <a:endParaRPr lang="en-US" altLang="ja-JP" sz="800">
                <a:latin typeface="Arial"/>
                <a:cs typeface="Arial"/>
              </a:endParaRPr>
            </a:p>
          </p:txBody>
        </p:sp>
        <p:sp>
          <p:nvSpPr>
            <p:cNvPr id="127" name="Rectangle 71"/>
            <p:cNvSpPr>
              <a:spLocks noChangeArrowheads="1"/>
            </p:cNvSpPr>
            <p:nvPr/>
          </p:nvSpPr>
          <p:spPr bwMode="auto">
            <a:xfrm rot="16200000">
              <a:off x="1658" y="2071"/>
              <a:ext cx="833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/>
                  <a:cs typeface="Arial"/>
                </a:rPr>
                <a:t>Relative level of expression</a:t>
              </a:r>
            </a:p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/>
                  <a:cs typeface="Arial"/>
                </a:rPr>
                <a:t> (</a:t>
              </a:r>
              <a:r>
                <a:rPr lang="en-US" altLang="ja-JP" sz="800" i="1" dirty="0">
                  <a:solidFill>
                    <a:srgbClr val="000000"/>
                  </a:solidFill>
                  <a:latin typeface="Arial"/>
                  <a:cs typeface="Arial"/>
                </a:rPr>
                <a:t>Foxp3/18S </a:t>
              </a:r>
              <a:r>
                <a:rPr lang="en-US" altLang="ja-JP" sz="800" i="1" dirty="0" err="1">
                  <a:solidFill>
                    <a:srgbClr val="000000"/>
                  </a:solidFill>
                  <a:latin typeface="Arial"/>
                  <a:cs typeface="Arial"/>
                </a:rPr>
                <a:t>rRNA</a:t>
              </a:r>
              <a:r>
                <a:rPr lang="en-US" altLang="ja-JP" sz="800" dirty="0">
                  <a:solidFill>
                    <a:srgbClr val="000000"/>
                  </a:solidFill>
                  <a:latin typeface="Arial"/>
                  <a:cs typeface="Arial"/>
                </a:rPr>
                <a:t>)</a:t>
              </a:r>
              <a:endParaRPr lang="en-US" altLang="ja-JP" sz="800" dirty="0">
                <a:latin typeface="Arial"/>
                <a:cs typeface="Arial"/>
              </a:endParaRPr>
            </a:p>
          </p:txBody>
        </p:sp>
      </p:grpSp>
      <p:grpSp>
        <p:nvGrpSpPr>
          <p:cNvPr id="7" name="図形グループ 6"/>
          <p:cNvGrpSpPr/>
          <p:nvPr/>
        </p:nvGrpSpPr>
        <p:grpSpPr>
          <a:xfrm>
            <a:off x="1268760" y="2006134"/>
            <a:ext cx="4464496" cy="2056293"/>
            <a:chOff x="1268760" y="349950"/>
            <a:chExt cx="4464496" cy="2056293"/>
          </a:xfrm>
        </p:grpSpPr>
        <p:grpSp>
          <p:nvGrpSpPr>
            <p:cNvPr id="3" name="図形グループ 2"/>
            <p:cNvGrpSpPr/>
            <p:nvPr/>
          </p:nvGrpSpPr>
          <p:grpSpPr>
            <a:xfrm>
              <a:off x="1268760" y="628494"/>
              <a:ext cx="1765948" cy="1546017"/>
              <a:chOff x="893332" y="469026"/>
              <a:chExt cx="1765948" cy="1546017"/>
            </a:xfrm>
          </p:grpSpPr>
          <p:grpSp>
            <p:nvGrpSpPr>
              <p:cNvPr id="75" name="グループ化 1"/>
              <p:cNvGrpSpPr>
                <a:grpSpLocks noChangeAspect="1"/>
              </p:cNvGrpSpPr>
              <p:nvPr/>
            </p:nvGrpSpPr>
            <p:grpSpPr>
              <a:xfrm>
                <a:off x="1332000" y="561373"/>
                <a:ext cx="1324099" cy="1330035"/>
                <a:chOff x="1742465" y="1569147"/>
                <a:chExt cx="2648198" cy="2660070"/>
              </a:xfrm>
            </p:grpSpPr>
            <p:sp>
              <p:nvSpPr>
                <p:cNvPr id="144" name="フリーフォーム 143"/>
                <p:cNvSpPr/>
                <p:nvPr/>
              </p:nvSpPr>
              <p:spPr>
                <a:xfrm>
                  <a:off x="2565070" y="1717588"/>
                  <a:ext cx="724395" cy="2505694"/>
                </a:xfrm>
                <a:custGeom>
                  <a:avLst/>
                  <a:gdLst>
                    <a:gd name="connsiteX0" fmla="*/ 724395 w 724395"/>
                    <a:gd name="connsiteY0" fmla="*/ 0 h 2505694"/>
                    <a:gd name="connsiteX1" fmla="*/ 700644 w 724395"/>
                    <a:gd name="connsiteY1" fmla="*/ 29688 h 2505694"/>
                    <a:gd name="connsiteX2" fmla="*/ 694707 w 724395"/>
                    <a:gd name="connsiteY2" fmla="*/ 71252 h 2505694"/>
                    <a:gd name="connsiteX3" fmla="*/ 688769 w 724395"/>
                    <a:gd name="connsiteY3" fmla="*/ 95003 h 2505694"/>
                    <a:gd name="connsiteX4" fmla="*/ 682831 w 724395"/>
                    <a:gd name="connsiteY4" fmla="*/ 124691 h 2505694"/>
                    <a:gd name="connsiteX5" fmla="*/ 670956 w 724395"/>
                    <a:gd name="connsiteY5" fmla="*/ 142504 h 2505694"/>
                    <a:gd name="connsiteX6" fmla="*/ 676894 w 724395"/>
                    <a:gd name="connsiteY6" fmla="*/ 219694 h 2505694"/>
                    <a:gd name="connsiteX7" fmla="*/ 682831 w 724395"/>
                    <a:gd name="connsiteY7" fmla="*/ 249382 h 2505694"/>
                    <a:gd name="connsiteX8" fmla="*/ 670956 w 724395"/>
                    <a:gd name="connsiteY8" fmla="*/ 362197 h 2505694"/>
                    <a:gd name="connsiteX9" fmla="*/ 665018 w 724395"/>
                    <a:gd name="connsiteY9" fmla="*/ 558140 h 2505694"/>
                    <a:gd name="connsiteX10" fmla="*/ 659081 w 724395"/>
                    <a:gd name="connsiteY10" fmla="*/ 575953 h 2505694"/>
                    <a:gd name="connsiteX11" fmla="*/ 653143 w 724395"/>
                    <a:gd name="connsiteY11" fmla="*/ 712520 h 2505694"/>
                    <a:gd name="connsiteX12" fmla="*/ 641268 w 724395"/>
                    <a:gd name="connsiteY12" fmla="*/ 730333 h 2505694"/>
                    <a:gd name="connsiteX13" fmla="*/ 653143 w 724395"/>
                    <a:gd name="connsiteY13" fmla="*/ 807522 h 2505694"/>
                    <a:gd name="connsiteX14" fmla="*/ 635330 w 724395"/>
                    <a:gd name="connsiteY14" fmla="*/ 997527 h 2505694"/>
                    <a:gd name="connsiteX15" fmla="*/ 641268 w 724395"/>
                    <a:gd name="connsiteY15" fmla="*/ 1151907 h 2505694"/>
                    <a:gd name="connsiteX16" fmla="*/ 647205 w 724395"/>
                    <a:gd name="connsiteY16" fmla="*/ 1169720 h 2505694"/>
                    <a:gd name="connsiteX17" fmla="*/ 635330 w 724395"/>
                    <a:gd name="connsiteY17" fmla="*/ 1282535 h 2505694"/>
                    <a:gd name="connsiteX18" fmla="*/ 623455 w 724395"/>
                    <a:gd name="connsiteY18" fmla="*/ 1300348 h 2505694"/>
                    <a:gd name="connsiteX19" fmla="*/ 635330 w 724395"/>
                    <a:gd name="connsiteY19" fmla="*/ 1347849 h 2505694"/>
                    <a:gd name="connsiteX20" fmla="*/ 623455 w 724395"/>
                    <a:gd name="connsiteY20" fmla="*/ 1537855 h 2505694"/>
                    <a:gd name="connsiteX21" fmla="*/ 617517 w 724395"/>
                    <a:gd name="connsiteY21" fmla="*/ 1704109 h 2505694"/>
                    <a:gd name="connsiteX22" fmla="*/ 611579 w 724395"/>
                    <a:gd name="connsiteY22" fmla="*/ 1721922 h 2505694"/>
                    <a:gd name="connsiteX23" fmla="*/ 605642 w 724395"/>
                    <a:gd name="connsiteY23" fmla="*/ 1799112 h 2505694"/>
                    <a:gd name="connsiteX24" fmla="*/ 593766 w 724395"/>
                    <a:gd name="connsiteY24" fmla="*/ 1834738 h 2505694"/>
                    <a:gd name="connsiteX25" fmla="*/ 599704 w 724395"/>
                    <a:gd name="connsiteY25" fmla="*/ 1882239 h 2505694"/>
                    <a:gd name="connsiteX26" fmla="*/ 587829 w 724395"/>
                    <a:gd name="connsiteY26" fmla="*/ 1947553 h 2505694"/>
                    <a:gd name="connsiteX27" fmla="*/ 581891 w 724395"/>
                    <a:gd name="connsiteY27" fmla="*/ 2036618 h 2505694"/>
                    <a:gd name="connsiteX28" fmla="*/ 575953 w 724395"/>
                    <a:gd name="connsiteY28" fmla="*/ 2054431 h 2505694"/>
                    <a:gd name="connsiteX29" fmla="*/ 570016 w 724395"/>
                    <a:gd name="connsiteY29" fmla="*/ 2119746 h 2505694"/>
                    <a:gd name="connsiteX30" fmla="*/ 558140 w 724395"/>
                    <a:gd name="connsiteY30" fmla="*/ 2167247 h 2505694"/>
                    <a:gd name="connsiteX31" fmla="*/ 552203 w 724395"/>
                    <a:gd name="connsiteY31" fmla="*/ 2256312 h 2505694"/>
                    <a:gd name="connsiteX32" fmla="*/ 546265 w 724395"/>
                    <a:gd name="connsiteY32" fmla="*/ 2274125 h 2505694"/>
                    <a:gd name="connsiteX33" fmla="*/ 528452 w 724395"/>
                    <a:gd name="connsiteY33" fmla="*/ 2286000 h 2505694"/>
                    <a:gd name="connsiteX34" fmla="*/ 504701 w 724395"/>
                    <a:gd name="connsiteY34" fmla="*/ 2315688 h 2505694"/>
                    <a:gd name="connsiteX35" fmla="*/ 486888 w 724395"/>
                    <a:gd name="connsiteY35" fmla="*/ 2309751 h 2505694"/>
                    <a:gd name="connsiteX36" fmla="*/ 480951 w 724395"/>
                    <a:gd name="connsiteY36" fmla="*/ 2327564 h 2505694"/>
                    <a:gd name="connsiteX37" fmla="*/ 451262 w 724395"/>
                    <a:gd name="connsiteY37" fmla="*/ 2345377 h 2505694"/>
                    <a:gd name="connsiteX38" fmla="*/ 433449 w 724395"/>
                    <a:gd name="connsiteY38" fmla="*/ 2357252 h 2505694"/>
                    <a:gd name="connsiteX39" fmla="*/ 415636 w 724395"/>
                    <a:gd name="connsiteY39" fmla="*/ 2345377 h 2505694"/>
                    <a:gd name="connsiteX40" fmla="*/ 380011 w 724395"/>
                    <a:gd name="connsiteY40" fmla="*/ 2363190 h 2505694"/>
                    <a:gd name="connsiteX41" fmla="*/ 362198 w 724395"/>
                    <a:gd name="connsiteY41" fmla="*/ 2369127 h 2505694"/>
                    <a:gd name="connsiteX42" fmla="*/ 296883 w 724395"/>
                    <a:gd name="connsiteY42" fmla="*/ 2363190 h 2505694"/>
                    <a:gd name="connsiteX43" fmla="*/ 285008 w 724395"/>
                    <a:gd name="connsiteY43" fmla="*/ 2351314 h 2505694"/>
                    <a:gd name="connsiteX44" fmla="*/ 267195 w 724395"/>
                    <a:gd name="connsiteY44" fmla="*/ 2345377 h 2505694"/>
                    <a:gd name="connsiteX45" fmla="*/ 231569 w 724395"/>
                    <a:gd name="connsiteY45" fmla="*/ 2351314 h 2505694"/>
                    <a:gd name="connsiteX46" fmla="*/ 225631 w 724395"/>
                    <a:gd name="connsiteY46" fmla="*/ 2369127 h 2505694"/>
                    <a:gd name="connsiteX47" fmla="*/ 190005 w 724395"/>
                    <a:gd name="connsiteY47" fmla="*/ 2381003 h 2505694"/>
                    <a:gd name="connsiteX48" fmla="*/ 184068 w 724395"/>
                    <a:gd name="connsiteY48" fmla="*/ 2398816 h 2505694"/>
                    <a:gd name="connsiteX49" fmla="*/ 166255 w 724395"/>
                    <a:gd name="connsiteY49" fmla="*/ 2404753 h 2505694"/>
                    <a:gd name="connsiteX50" fmla="*/ 130629 w 724395"/>
                    <a:gd name="connsiteY50" fmla="*/ 2428504 h 2505694"/>
                    <a:gd name="connsiteX51" fmla="*/ 106878 w 724395"/>
                    <a:gd name="connsiteY51" fmla="*/ 2452255 h 2505694"/>
                    <a:gd name="connsiteX52" fmla="*/ 89065 w 724395"/>
                    <a:gd name="connsiteY52" fmla="*/ 2458192 h 2505694"/>
                    <a:gd name="connsiteX53" fmla="*/ 35626 w 724395"/>
                    <a:gd name="connsiteY53" fmla="*/ 2470068 h 2505694"/>
                    <a:gd name="connsiteX54" fmla="*/ 17813 w 724395"/>
                    <a:gd name="connsiteY54" fmla="*/ 2481943 h 2505694"/>
                    <a:gd name="connsiteX55" fmla="*/ 5938 w 724395"/>
                    <a:gd name="connsiteY55" fmla="*/ 2499756 h 2505694"/>
                    <a:gd name="connsiteX56" fmla="*/ 0 w 724395"/>
                    <a:gd name="connsiteY56" fmla="*/ 2505694 h 250569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</a:cxnLst>
                  <a:rect l="l" t="t" r="r" b="b"/>
                  <a:pathLst>
                    <a:path w="724395" h="2505694">
                      <a:moveTo>
                        <a:pt x="724395" y="0"/>
                      </a:moveTo>
                      <a:cubicBezTo>
                        <a:pt x="716478" y="9896"/>
                        <a:pt x="705518" y="17990"/>
                        <a:pt x="700644" y="29688"/>
                      </a:cubicBezTo>
                      <a:cubicBezTo>
                        <a:pt x="695261" y="42607"/>
                        <a:pt x="697210" y="57482"/>
                        <a:pt x="694707" y="71252"/>
                      </a:cubicBezTo>
                      <a:cubicBezTo>
                        <a:pt x="693247" y="79281"/>
                        <a:pt x="690539" y="87037"/>
                        <a:pt x="688769" y="95003"/>
                      </a:cubicBezTo>
                      <a:cubicBezTo>
                        <a:pt x="686580" y="104855"/>
                        <a:pt x="686375" y="115242"/>
                        <a:pt x="682831" y="124691"/>
                      </a:cubicBezTo>
                      <a:cubicBezTo>
                        <a:pt x="680325" y="131373"/>
                        <a:pt x="674914" y="136566"/>
                        <a:pt x="670956" y="142504"/>
                      </a:cubicBezTo>
                      <a:cubicBezTo>
                        <a:pt x="672935" y="168234"/>
                        <a:pt x="674044" y="194046"/>
                        <a:pt x="676894" y="219694"/>
                      </a:cubicBezTo>
                      <a:cubicBezTo>
                        <a:pt x="678008" y="229724"/>
                        <a:pt x="682831" y="239290"/>
                        <a:pt x="682831" y="249382"/>
                      </a:cubicBezTo>
                      <a:cubicBezTo>
                        <a:pt x="682831" y="331650"/>
                        <a:pt x="685680" y="318027"/>
                        <a:pt x="670956" y="362197"/>
                      </a:cubicBezTo>
                      <a:cubicBezTo>
                        <a:pt x="668977" y="427511"/>
                        <a:pt x="668643" y="492896"/>
                        <a:pt x="665018" y="558140"/>
                      </a:cubicBezTo>
                      <a:cubicBezTo>
                        <a:pt x="664671" y="564389"/>
                        <a:pt x="659561" y="569713"/>
                        <a:pt x="659081" y="575953"/>
                      </a:cubicBezTo>
                      <a:cubicBezTo>
                        <a:pt x="655586" y="621384"/>
                        <a:pt x="658366" y="667255"/>
                        <a:pt x="653143" y="712520"/>
                      </a:cubicBezTo>
                      <a:cubicBezTo>
                        <a:pt x="652325" y="719609"/>
                        <a:pt x="645226" y="724395"/>
                        <a:pt x="641268" y="730333"/>
                      </a:cubicBezTo>
                      <a:cubicBezTo>
                        <a:pt x="648438" y="759014"/>
                        <a:pt x="653143" y="773332"/>
                        <a:pt x="653143" y="807522"/>
                      </a:cubicBezTo>
                      <a:cubicBezTo>
                        <a:pt x="653143" y="977570"/>
                        <a:pt x="678293" y="933080"/>
                        <a:pt x="635330" y="997527"/>
                      </a:cubicBezTo>
                      <a:cubicBezTo>
                        <a:pt x="637309" y="1048987"/>
                        <a:pt x="637725" y="1100531"/>
                        <a:pt x="641268" y="1151907"/>
                      </a:cubicBezTo>
                      <a:cubicBezTo>
                        <a:pt x="641699" y="1158151"/>
                        <a:pt x="647205" y="1163461"/>
                        <a:pt x="647205" y="1169720"/>
                      </a:cubicBezTo>
                      <a:cubicBezTo>
                        <a:pt x="647205" y="1177358"/>
                        <a:pt x="650054" y="1253087"/>
                        <a:pt x="635330" y="1282535"/>
                      </a:cubicBezTo>
                      <a:cubicBezTo>
                        <a:pt x="632139" y="1288918"/>
                        <a:pt x="627413" y="1294410"/>
                        <a:pt x="623455" y="1300348"/>
                      </a:cubicBezTo>
                      <a:cubicBezTo>
                        <a:pt x="627413" y="1316182"/>
                        <a:pt x="635892" y="1331538"/>
                        <a:pt x="635330" y="1347849"/>
                      </a:cubicBezTo>
                      <a:cubicBezTo>
                        <a:pt x="629176" y="1526297"/>
                        <a:pt x="647552" y="1465557"/>
                        <a:pt x="623455" y="1537855"/>
                      </a:cubicBezTo>
                      <a:cubicBezTo>
                        <a:pt x="621476" y="1593273"/>
                        <a:pt x="621087" y="1648771"/>
                        <a:pt x="617517" y="1704109"/>
                      </a:cubicBezTo>
                      <a:cubicBezTo>
                        <a:pt x="617114" y="1710355"/>
                        <a:pt x="612355" y="1715711"/>
                        <a:pt x="611579" y="1721922"/>
                      </a:cubicBezTo>
                      <a:cubicBezTo>
                        <a:pt x="608378" y="1747529"/>
                        <a:pt x="609667" y="1773622"/>
                        <a:pt x="605642" y="1799112"/>
                      </a:cubicBezTo>
                      <a:cubicBezTo>
                        <a:pt x="603690" y="1811477"/>
                        <a:pt x="593766" y="1834738"/>
                        <a:pt x="593766" y="1834738"/>
                      </a:cubicBezTo>
                      <a:cubicBezTo>
                        <a:pt x="595745" y="1850572"/>
                        <a:pt x="599704" y="1866282"/>
                        <a:pt x="599704" y="1882239"/>
                      </a:cubicBezTo>
                      <a:cubicBezTo>
                        <a:pt x="599704" y="1915805"/>
                        <a:pt x="596178" y="1922503"/>
                        <a:pt x="587829" y="1947553"/>
                      </a:cubicBezTo>
                      <a:cubicBezTo>
                        <a:pt x="585850" y="1977241"/>
                        <a:pt x="585177" y="2007046"/>
                        <a:pt x="581891" y="2036618"/>
                      </a:cubicBezTo>
                      <a:cubicBezTo>
                        <a:pt x="581200" y="2042839"/>
                        <a:pt x="576838" y="2048235"/>
                        <a:pt x="575953" y="2054431"/>
                      </a:cubicBezTo>
                      <a:cubicBezTo>
                        <a:pt x="572861" y="2076073"/>
                        <a:pt x="573426" y="2098152"/>
                        <a:pt x="570016" y="2119746"/>
                      </a:cubicBezTo>
                      <a:cubicBezTo>
                        <a:pt x="567471" y="2135867"/>
                        <a:pt x="558140" y="2167247"/>
                        <a:pt x="558140" y="2167247"/>
                      </a:cubicBezTo>
                      <a:cubicBezTo>
                        <a:pt x="556161" y="2196935"/>
                        <a:pt x="555489" y="2226740"/>
                        <a:pt x="552203" y="2256312"/>
                      </a:cubicBezTo>
                      <a:cubicBezTo>
                        <a:pt x="551512" y="2262533"/>
                        <a:pt x="550175" y="2269238"/>
                        <a:pt x="546265" y="2274125"/>
                      </a:cubicBezTo>
                      <a:cubicBezTo>
                        <a:pt x="541807" y="2279697"/>
                        <a:pt x="534390" y="2282042"/>
                        <a:pt x="528452" y="2286000"/>
                      </a:cubicBezTo>
                      <a:cubicBezTo>
                        <a:pt x="523820" y="2299894"/>
                        <a:pt x="523659" y="2312528"/>
                        <a:pt x="504701" y="2315688"/>
                      </a:cubicBezTo>
                      <a:cubicBezTo>
                        <a:pt x="498527" y="2316717"/>
                        <a:pt x="492826" y="2311730"/>
                        <a:pt x="486888" y="2309751"/>
                      </a:cubicBezTo>
                      <a:cubicBezTo>
                        <a:pt x="484909" y="2315689"/>
                        <a:pt x="484171" y="2322197"/>
                        <a:pt x="480951" y="2327564"/>
                      </a:cubicBezTo>
                      <a:cubicBezTo>
                        <a:pt x="471011" y="2344130"/>
                        <a:pt x="467273" y="2337372"/>
                        <a:pt x="451262" y="2345377"/>
                      </a:cubicBezTo>
                      <a:cubicBezTo>
                        <a:pt x="444879" y="2348568"/>
                        <a:pt x="439387" y="2353294"/>
                        <a:pt x="433449" y="2357252"/>
                      </a:cubicBezTo>
                      <a:cubicBezTo>
                        <a:pt x="427511" y="2353294"/>
                        <a:pt x="422700" y="2346386"/>
                        <a:pt x="415636" y="2345377"/>
                      </a:cubicBezTo>
                      <a:cubicBezTo>
                        <a:pt x="388035" y="2341434"/>
                        <a:pt x="396572" y="2353253"/>
                        <a:pt x="380011" y="2363190"/>
                      </a:cubicBezTo>
                      <a:cubicBezTo>
                        <a:pt x="374644" y="2366410"/>
                        <a:pt x="368136" y="2367148"/>
                        <a:pt x="362198" y="2369127"/>
                      </a:cubicBezTo>
                      <a:cubicBezTo>
                        <a:pt x="340426" y="2367148"/>
                        <a:pt x="318185" y="2368106"/>
                        <a:pt x="296883" y="2363190"/>
                      </a:cubicBezTo>
                      <a:cubicBezTo>
                        <a:pt x="291428" y="2361931"/>
                        <a:pt x="289808" y="2354194"/>
                        <a:pt x="285008" y="2351314"/>
                      </a:cubicBezTo>
                      <a:cubicBezTo>
                        <a:pt x="279641" y="2348094"/>
                        <a:pt x="273133" y="2347356"/>
                        <a:pt x="267195" y="2345377"/>
                      </a:cubicBezTo>
                      <a:cubicBezTo>
                        <a:pt x="255320" y="2347356"/>
                        <a:pt x="242022" y="2345341"/>
                        <a:pt x="231569" y="2351314"/>
                      </a:cubicBezTo>
                      <a:cubicBezTo>
                        <a:pt x="226135" y="2354419"/>
                        <a:pt x="230724" y="2365489"/>
                        <a:pt x="225631" y="2369127"/>
                      </a:cubicBezTo>
                      <a:cubicBezTo>
                        <a:pt x="215445" y="2376403"/>
                        <a:pt x="190005" y="2381003"/>
                        <a:pt x="190005" y="2381003"/>
                      </a:cubicBezTo>
                      <a:cubicBezTo>
                        <a:pt x="188026" y="2386941"/>
                        <a:pt x="188494" y="2394390"/>
                        <a:pt x="184068" y="2398816"/>
                      </a:cubicBezTo>
                      <a:cubicBezTo>
                        <a:pt x="179642" y="2403242"/>
                        <a:pt x="171726" y="2401713"/>
                        <a:pt x="166255" y="2404753"/>
                      </a:cubicBezTo>
                      <a:cubicBezTo>
                        <a:pt x="153779" y="2411684"/>
                        <a:pt x="140721" y="2418412"/>
                        <a:pt x="130629" y="2428504"/>
                      </a:cubicBezTo>
                      <a:cubicBezTo>
                        <a:pt x="122712" y="2436421"/>
                        <a:pt x="117500" y="2448715"/>
                        <a:pt x="106878" y="2452255"/>
                      </a:cubicBezTo>
                      <a:cubicBezTo>
                        <a:pt x="100940" y="2454234"/>
                        <a:pt x="95083" y="2456473"/>
                        <a:pt x="89065" y="2458192"/>
                      </a:cubicBezTo>
                      <a:cubicBezTo>
                        <a:pt x="69495" y="2463783"/>
                        <a:pt x="56038" y="2465985"/>
                        <a:pt x="35626" y="2470068"/>
                      </a:cubicBezTo>
                      <a:cubicBezTo>
                        <a:pt x="29688" y="2474026"/>
                        <a:pt x="22859" y="2476897"/>
                        <a:pt x="17813" y="2481943"/>
                      </a:cubicBezTo>
                      <a:cubicBezTo>
                        <a:pt x="12767" y="2486989"/>
                        <a:pt x="10220" y="2494047"/>
                        <a:pt x="5938" y="2499756"/>
                      </a:cubicBezTo>
                      <a:cubicBezTo>
                        <a:pt x="4258" y="2501995"/>
                        <a:pt x="1979" y="2503715"/>
                        <a:pt x="0" y="2505694"/>
                      </a:cubicBezTo>
                    </a:path>
                  </a:pathLst>
                </a:custGeom>
                <a:noFill/>
                <a:ln w="635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/>
                    <a:cs typeface="Arial"/>
                  </a:endParaRPr>
                </a:p>
              </p:txBody>
            </p:sp>
            <p:sp>
              <p:nvSpPr>
                <p:cNvPr id="145" name="フリーフォーム 144"/>
                <p:cNvSpPr/>
                <p:nvPr/>
              </p:nvSpPr>
              <p:spPr>
                <a:xfrm>
                  <a:off x="3281924" y="1705710"/>
                  <a:ext cx="558140" cy="2523507"/>
                </a:xfrm>
                <a:custGeom>
                  <a:avLst/>
                  <a:gdLst>
                    <a:gd name="connsiteX0" fmla="*/ 0 w 558140"/>
                    <a:gd name="connsiteY0" fmla="*/ 0 h 2523507"/>
                    <a:gd name="connsiteX1" fmla="*/ 5937 w 558140"/>
                    <a:gd name="connsiteY1" fmla="*/ 29689 h 2523507"/>
                    <a:gd name="connsiteX2" fmla="*/ 23750 w 558140"/>
                    <a:gd name="connsiteY2" fmla="*/ 190006 h 2523507"/>
                    <a:gd name="connsiteX3" fmla="*/ 29688 w 558140"/>
                    <a:gd name="connsiteY3" fmla="*/ 320634 h 2523507"/>
                    <a:gd name="connsiteX4" fmla="*/ 35626 w 558140"/>
                    <a:gd name="connsiteY4" fmla="*/ 338447 h 2523507"/>
                    <a:gd name="connsiteX5" fmla="*/ 41563 w 558140"/>
                    <a:gd name="connsiteY5" fmla="*/ 219694 h 2523507"/>
                    <a:gd name="connsiteX6" fmla="*/ 59376 w 558140"/>
                    <a:gd name="connsiteY6" fmla="*/ 498764 h 2523507"/>
                    <a:gd name="connsiteX7" fmla="*/ 53439 w 558140"/>
                    <a:gd name="connsiteY7" fmla="*/ 534390 h 2523507"/>
                    <a:gd name="connsiteX8" fmla="*/ 59376 w 558140"/>
                    <a:gd name="connsiteY8" fmla="*/ 831273 h 2523507"/>
                    <a:gd name="connsiteX9" fmla="*/ 65314 w 558140"/>
                    <a:gd name="connsiteY9" fmla="*/ 849086 h 2523507"/>
                    <a:gd name="connsiteX10" fmla="*/ 71252 w 558140"/>
                    <a:gd name="connsiteY10" fmla="*/ 997528 h 2523507"/>
                    <a:gd name="connsiteX11" fmla="*/ 77189 w 558140"/>
                    <a:gd name="connsiteY11" fmla="*/ 1116281 h 2523507"/>
                    <a:gd name="connsiteX12" fmla="*/ 89065 w 558140"/>
                    <a:gd name="connsiteY12" fmla="*/ 1413164 h 2523507"/>
                    <a:gd name="connsiteX13" fmla="*/ 95002 w 558140"/>
                    <a:gd name="connsiteY13" fmla="*/ 1579419 h 2523507"/>
                    <a:gd name="connsiteX14" fmla="*/ 100940 w 558140"/>
                    <a:gd name="connsiteY14" fmla="*/ 1597232 h 2523507"/>
                    <a:gd name="connsiteX15" fmla="*/ 106878 w 558140"/>
                    <a:gd name="connsiteY15" fmla="*/ 1757548 h 2523507"/>
                    <a:gd name="connsiteX16" fmla="*/ 118753 w 558140"/>
                    <a:gd name="connsiteY16" fmla="*/ 1816925 h 2523507"/>
                    <a:gd name="connsiteX17" fmla="*/ 124691 w 558140"/>
                    <a:gd name="connsiteY17" fmla="*/ 1971304 h 2523507"/>
                    <a:gd name="connsiteX18" fmla="*/ 130628 w 558140"/>
                    <a:gd name="connsiteY18" fmla="*/ 1989117 h 2523507"/>
                    <a:gd name="connsiteX19" fmla="*/ 142504 w 558140"/>
                    <a:gd name="connsiteY19" fmla="*/ 2060369 h 2523507"/>
                    <a:gd name="connsiteX20" fmla="*/ 148441 w 558140"/>
                    <a:gd name="connsiteY20" fmla="*/ 2095995 h 2523507"/>
                    <a:gd name="connsiteX21" fmla="*/ 166254 w 558140"/>
                    <a:gd name="connsiteY21" fmla="*/ 2196935 h 2523507"/>
                    <a:gd name="connsiteX22" fmla="*/ 178129 w 558140"/>
                    <a:gd name="connsiteY22" fmla="*/ 2208811 h 2523507"/>
                    <a:gd name="connsiteX23" fmla="*/ 184067 w 558140"/>
                    <a:gd name="connsiteY23" fmla="*/ 2262250 h 2523507"/>
                    <a:gd name="connsiteX24" fmla="*/ 195942 w 558140"/>
                    <a:gd name="connsiteY24" fmla="*/ 2297876 h 2523507"/>
                    <a:gd name="connsiteX25" fmla="*/ 201880 w 558140"/>
                    <a:gd name="connsiteY25" fmla="*/ 2315689 h 2523507"/>
                    <a:gd name="connsiteX26" fmla="*/ 213755 w 558140"/>
                    <a:gd name="connsiteY26" fmla="*/ 2363190 h 2523507"/>
                    <a:gd name="connsiteX27" fmla="*/ 225631 w 558140"/>
                    <a:gd name="connsiteY27" fmla="*/ 2375065 h 2523507"/>
                    <a:gd name="connsiteX28" fmla="*/ 231568 w 558140"/>
                    <a:gd name="connsiteY28" fmla="*/ 2392878 h 2523507"/>
                    <a:gd name="connsiteX29" fmla="*/ 255319 w 558140"/>
                    <a:gd name="connsiteY29" fmla="*/ 2422567 h 2523507"/>
                    <a:gd name="connsiteX30" fmla="*/ 290945 w 558140"/>
                    <a:gd name="connsiteY30" fmla="*/ 2446317 h 2523507"/>
                    <a:gd name="connsiteX31" fmla="*/ 308758 w 558140"/>
                    <a:gd name="connsiteY31" fmla="*/ 2452255 h 2523507"/>
                    <a:gd name="connsiteX32" fmla="*/ 326571 w 558140"/>
                    <a:gd name="connsiteY32" fmla="*/ 2464130 h 2523507"/>
                    <a:gd name="connsiteX33" fmla="*/ 362197 w 558140"/>
                    <a:gd name="connsiteY33" fmla="*/ 2476006 h 2523507"/>
                    <a:gd name="connsiteX34" fmla="*/ 380010 w 558140"/>
                    <a:gd name="connsiteY34" fmla="*/ 2481943 h 2523507"/>
                    <a:gd name="connsiteX35" fmla="*/ 439387 w 558140"/>
                    <a:gd name="connsiteY35" fmla="*/ 2487881 h 2523507"/>
                    <a:gd name="connsiteX36" fmla="*/ 457200 w 558140"/>
                    <a:gd name="connsiteY36" fmla="*/ 2493819 h 2523507"/>
                    <a:gd name="connsiteX37" fmla="*/ 475013 w 558140"/>
                    <a:gd name="connsiteY37" fmla="*/ 2505694 h 2523507"/>
                    <a:gd name="connsiteX38" fmla="*/ 516576 w 558140"/>
                    <a:gd name="connsiteY38" fmla="*/ 2511632 h 2523507"/>
                    <a:gd name="connsiteX39" fmla="*/ 552202 w 558140"/>
                    <a:gd name="connsiteY39" fmla="*/ 2517569 h 2523507"/>
                    <a:gd name="connsiteX40" fmla="*/ 558140 w 558140"/>
                    <a:gd name="connsiteY40" fmla="*/ 2523507 h 252350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</a:cxnLst>
                  <a:rect l="l" t="t" r="r" b="b"/>
                  <a:pathLst>
                    <a:path w="558140" h="2523507">
                      <a:moveTo>
                        <a:pt x="0" y="0"/>
                      </a:moveTo>
                      <a:cubicBezTo>
                        <a:pt x="1979" y="9896"/>
                        <a:pt x="5266" y="19619"/>
                        <a:pt x="5937" y="29689"/>
                      </a:cubicBezTo>
                      <a:cubicBezTo>
                        <a:pt x="16499" y="188124"/>
                        <a:pt x="-23637" y="142615"/>
                        <a:pt x="23750" y="190006"/>
                      </a:cubicBezTo>
                      <a:cubicBezTo>
                        <a:pt x="25729" y="233549"/>
                        <a:pt x="26212" y="277185"/>
                        <a:pt x="29688" y="320634"/>
                      </a:cubicBezTo>
                      <a:cubicBezTo>
                        <a:pt x="30187" y="326873"/>
                        <a:pt x="34895" y="344663"/>
                        <a:pt x="35626" y="338447"/>
                      </a:cubicBezTo>
                      <a:cubicBezTo>
                        <a:pt x="40257" y="299085"/>
                        <a:pt x="39584" y="259278"/>
                        <a:pt x="41563" y="219694"/>
                      </a:cubicBezTo>
                      <a:cubicBezTo>
                        <a:pt x="74550" y="318649"/>
                        <a:pt x="54460" y="252983"/>
                        <a:pt x="59376" y="498764"/>
                      </a:cubicBezTo>
                      <a:cubicBezTo>
                        <a:pt x="59617" y="510801"/>
                        <a:pt x="55418" y="522515"/>
                        <a:pt x="53439" y="534390"/>
                      </a:cubicBezTo>
                      <a:cubicBezTo>
                        <a:pt x="55418" y="633351"/>
                        <a:pt x="55644" y="732363"/>
                        <a:pt x="59376" y="831273"/>
                      </a:cubicBezTo>
                      <a:cubicBezTo>
                        <a:pt x="59612" y="837527"/>
                        <a:pt x="64868" y="842843"/>
                        <a:pt x="65314" y="849086"/>
                      </a:cubicBezTo>
                      <a:cubicBezTo>
                        <a:pt x="68842" y="898480"/>
                        <a:pt x="69053" y="948057"/>
                        <a:pt x="71252" y="997528"/>
                      </a:cubicBezTo>
                      <a:cubicBezTo>
                        <a:pt x="73012" y="1037123"/>
                        <a:pt x="75823" y="1076671"/>
                        <a:pt x="77189" y="1116281"/>
                      </a:cubicBezTo>
                      <a:cubicBezTo>
                        <a:pt x="87228" y="1407424"/>
                        <a:pt x="75778" y="1253730"/>
                        <a:pt x="89065" y="1413164"/>
                      </a:cubicBezTo>
                      <a:cubicBezTo>
                        <a:pt x="91044" y="1468582"/>
                        <a:pt x="91432" y="1524080"/>
                        <a:pt x="95002" y="1579419"/>
                      </a:cubicBezTo>
                      <a:cubicBezTo>
                        <a:pt x="95405" y="1585665"/>
                        <a:pt x="100524" y="1590987"/>
                        <a:pt x="100940" y="1597232"/>
                      </a:cubicBezTo>
                      <a:cubicBezTo>
                        <a:pt x="104497" y="1650589"/>
                        <a:pt x="102556" y="1704248"/>
                        <a:pt x="106878" y="1757548"/>
                      </a:cubicBezTo>
                      <a:cubicBezTo>
                        <a:pt x="108509" y="1777666"/>
                        <a:pt x="118753" y="1816925"/>
                        <a:pt x="118753" y="1816925"/>
                      </a:cubicBezTo>
                      <a:cubicBezTo>
                        <a:pt x="120732" y="1868385"/>
                        <a:pt x="121148" y="1919928"/>
                        <a:pt x="124691" y="1971304"/>
                      </a:cubicBezTo>
                      <a:cubicBezTo>
                        <a:pt x="125122" y="1977548"/>
                        <a:pt x="129599" y="1982943"/>
                        <a:pt x="130628" y="1989117"/>
                      </a:cubicBezTo>
                      <a:cubicBezTo>
                        <a:pt x="143884" y="2068656"/>
                        <a:pt x="128584" y="2018611"/>
                        <a:pt x="142504" y="2060369"/>
                      </a:cubicBezTo>
                      <a:cubicBezTo>
                        <a:pt x="144483" y="2072244"/>
                        <a:pt x="147034" y="2084038"/>
                        <a:pt x="148441" y="2095995"/>
                      </a:cubicBezTo>
                      <a:cubicBezTo>
                        <a:pt x="149119" y="2101758"/>
                        <a:pt x="151126" y="2181806"/>
                        <a:pt x="166254" y="2196935"/>
                      </a:cubicBezTo>
                      <a:lnTo>
                        <a:pt x="178129" y="2208811"/>
                      </a:lnTo>
                      <a:cubicBezTo>
                        <a:pt x="180108" y="2226624"/>
                        <a:pt x="180552" y="2244675"/>
                        <a:pt x="184067" y="2262250"/>
                      </a:cubicBezTo>
                      <a:cubicBezTo>
                        <a:pt x="186522" y="2274525"/>
                        <a:pt x="191984" y="2286001"/>
                        <a:pt x="195942" y="2297876"/>
                      </a:cubicBezTo>
                      <a:cubicBezTo>
                        <a:pt x="197921" y="2303814"/>
                        <a:pt x="200652" y="2309552"/>
                        <a:pt x="201880" y="2315689"/>
                      </a:cubicBezTo>
                      <a:cubicBezTo>
                        <a:pt x="203156" y="2322068"/>
                        <a:pt x="208279" y="2354064"/>
                        <a:pt x="213755" y="2363190"/>
                      </a:cubicBezTo>
                      <a:cubicBezTo>
                        <a:pt x="216635" y="2367990"/>
                        <a:pt x="221672" y="2371107"/>
                        <a:pt x="225631" y="2375065"/>
                      </a:cubicBezTo>
                      <a:cubicBezTo>
                        <a:pt x="227610" y="2381003"/>
                        <a:pt x="228769" y="2387280"/>
                        <a:pt x="231568" y="2392878"/>
                      </a:cubicBezTo>
                      <a:cubicBezTo>
                        <a:pt x="236240" y="2402223"/>
                        <a:pt x="246485" y="2415942"/>
                        <a:pt x="255319" y="2422567"/>
                      </a:cubicBezTo>
                      <a:cubicBezTo>
                        <a:pt x="266737" y="2431130"/>
                        <a:pt x="277405" y="2441803"/>
                        <a:pt x="290945" y="2446317"/>
                      </a:cubicBezTo>
                      <a:cubicBezTo>
                        <a:pt x="296883" y="2448296"/>
                        <a:pt x="303160" y="2449456"/>
                        <a:pt x="308758" y="2452255"/>
                      </a:cubicBezTo>
                      <a:cubicBezTo>
                        <a:pt x="315141" y="2455446"/>
                        <a:pt x="320050" y="2461232"/>
                        <a:pt x="326571" y="2464130"/>
                      </a:cubicBezTo>
                      <a:cubicBezTo>
                        <a:pt x="338010" y="2469214"/>
                        <a:pt x="350322" y="2472048"/>
                        <a:pt x="362197" y="2476006"/>
                      </a:cubicBezTo>
                      <a:cubicBezTo>
                        <a:pt x="368135" y="2477985"/>
                        <a:pt x="373782" y="2481320"/>
                        <a:pt x="380010" y="2481943"/>
                      </a:cubicBezTo>
                      <a:lnTo>
                        <a:pt x="439387" y="2487881"/>
                      </a:lnTo>
                      <a:cubicBezTo>
                        <a:pt x="445325" y="2489860"/>
                        <a:pt x="451602" y="2491020"/>
                        <a:pt x="457200" y="2493819"/>
                      </a:cubicBezTo>
                      <a:cubicBezTo>
                        <a:pt x="463583" y="2497010"/>
                        <a:pt x="468178" y="2503643"/>
                        <a:pt x="475013" y="2505694"/>
                      </a:cubicBezTo>
                      <a:cubicBezTo>
                        <a:pt x="488418" y="2509715"/>
                        <a:pt x="502744" y="2509504"/>
                        <a:pt x="516576" y="2511632"/>
                      </a:cubicBezTo>
                      <a:cubicBezTo>
                        <a:pt x="528475" y="2513463"/>
                        <a:pt x="540626" y="2514262"/>
                        <a:pt x="552202" y="2517569"/>
                      </a:cubicBezTo>
                      <a:cubicBezTo>
                        <a:pt x="554894" y="2518338"/>
                        <a:pt x="556161" y="2521528"/>
                        <a:pt x="558140" y="2523507"/>
                      </a:cubicBezTo>
                    </a:path>
                  </a:pathLst>
                </a:custGeom>
                <a:noFill/>
                <a:ln w="635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/>
                    <a:cs typeface="Arial"/>
                  </a:endParaRPr>
                </a:p>
              </p:txBody>
            </p:sp>
            <p:sp>
              <p:nvSpPr>
                <p:cNvPr id="146" name="正方形/長方形 145"/>
                <p:cNvSpPr/>
                <p:nvPr/>
              </p:nvSpPr>
              <p:spPr>
                <a:xfrm>
                  <a:off x="1742465" y="1569147"/>
                  <a:ext cx="2648198" cy="2654135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/>
                    <a:cs typeface="Arial"/>
                  </a:endParaRPr>
                </a:p>
              </p:txBody>
            </p:sp>
            <p:cxnSp>
              <p:nvCxnSpPr>
                <p:cNvPr id="147" name="直線コネクタ 146"/>
                <p:cNvCxnSpPr/>
                <p:nvPr/>
              </p:nvCxnSpPr>
              <p:spPr>
                <a:xfrm>
                  <a:off x="3015916" y="3941011"/>
                  <a:ext cx="0" cy="112294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8" name="直線コネクタ 147"/>
                <p:cNvCxnSpPr/>
                <p:nvPr/>
              </p:nvCxnSpPr>
              <p:spPr>
                <a:xfrm>
                  <a:off x="3900855" y="3941011"/>
                  <a:ext cx="0" cy="112294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直線コネクタ 148"/>
                <p:cNvCxnSpPr/>
                <p:nvPr/>
              </p:nvCxnSpPr>
              <p:spPr>
                <a:xfrm>
                  <a:off x="3015916" y="3997158"/>
                  <a:ext cx="884939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7" name="Rectangle 97"/>
              <p:cNvSpPr>
                <a:spLocks noChangeArrowheads="1"/>
              </p:cNvSpPr>
              <p:nvPr/>
            </p:nvSpPr>
            <p:spPr bwMode="auto">
              <a:xfrm>
                <a:off x="2113930" y="1629431"/>
                <a:ext cx="234950" cy="123111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1.2</a:t>
                </a:r>
                <a:endParaRPr lang="en-US" altLang="ja-JP" sz="800" dirty="0">
                  <a:latin typeface="Arial"/>
                  <a:ea typeface="Arial" charset="0"/>
                  <a:cs typeface="Arial"/>
                </a:endParaRPr>
              </a:p>
            </p:txBody>
          </p:sp>
          <p:grpSp>
            <p:nvGrpSpPr>
              <p:cNvPr id="160" name="グループ化 18"/>
              <p:cNvGrpSpPr/>
              <p:nvPr/>
            </p:nvGrpSpPr>
            <p:grpSpPr>
              <a:xfrm>
                <a:off x="893332" y="469026"/>
                <a:ext cx="434979" cy="1546017"/>
                <a:chOff x="632116" y="1462180"/>
                <a:chExt cx="434979" cy="3002730"/>
              </a:xfrm>
            </p:grpSpPr>
            <p:grpSp>
              <p:nvGrpSpPr>
                <p:cNvPr id="161" name="グループ化 28"/>
                <p:cNvGrpSpPr/>
                <p:nvPr/>
              </p:nvGrpSpPr>
              <p:grpSpPr>
                <a:xfrm>
                  <a:off x="989906" y="1686294"/>
                  <a:ext cx="77189" cy="2537488"/>
                  <a:chOff x="1662546" y="1686294"/>
                  <a:chExt cx="77189" cy="2537488"/>
                </a:xfrm>
              </p:grpSpPr>
              <p:cxnSp>
                <p:nvCxnSpPr>
                  <p:cNvPr id="166" name="直線コネクタ 165"/>
                  <p:cNvCxnSpPr/>
                  <p:nvPr/>
                </p:nvCxnSpPr>
                <p:spPr>
                  <a:xfrm>
                    <a:off x="1662546" y="1686294"/>
                    <a:ext cx="77189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7" name="直線コネクタ 166"/>
                  <p:cNvCxnSpPr/>
                  <p:nvPr/>
                </p:nvCxnSpPr>
                <p:spPr>
                  <a:xfrm>
                    <a:off x="1685735" y="1897751"/>
                    <a:ext cx="5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8" name="直線コネクタ 167"/>
                  <p:cNvCxnSpPr/>
                  <p:nvPr/>
                </p:nvCxnSpPr>
                <p:spPr>
                  <a:xfrm>
                    <a:off x="1685735" y="2109208"/>
                    <a:ext cx="5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9" name="直線コネクタ 168"/>
                  <p:cNvCxnSpPr/>
                  <p:nvPr/>
                </p:nvCxnSpPr>
                <p:spPr>
                  <a:xfrm>
                    <a:off x="1685735" y="2320665"/>
                    <a:ext cx="5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0" name="直線コネクタ 169"/>
                  <p:cNvCxnSpPr/>
                  <p:nvPr/>
                </p:nvCxnSpPr>
                <p:spPr>
                  <a:xfrm>
                    <a:off x="1685735" y="2743579"/>
                    <a:ext cx="5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1" name="直線コネクタ 170"/>
                  <p:cNvCxnSpPr/>
                  <p:nvPr/>
                </p:nvCxnSpPr>
                <p:spPr>
                  <a:xfrm>
                    <a:off x="1685735" y="2955036"/>
                    <a:ext cx="5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2" name="直線コネクタ 171"/>
                  <p:cNvCxnSpPr/>
                  <p:nvPr/>
                </p:nvCxnSpPr>
                <p:spPr>
                  <a:xfrm>
                    <a:off x="1685735" y="3166493"/>
                    <a:ext cx="5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3" name="直線コネクタ 172"/>
                  <p:cNvCxnSpPr/>
                  <p:nvPr/>
                </p:nvCxnSpPr>
                <p:spPr>
                  <a:xfrm>
                    <a:off x="1685735" y="4012321"/>
                    <a:ext cx="5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4" name="直線コネクタ 173"/>
                  <p:cNvCxnSpPr/>
                  <p:nvPr/>
                </p:nvCxnSpPr>
                <p:spPr>
                  <a:xfrm>
                    <a:off x="1685735" y="3589407"/>
                    <a:ext cx="5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5" name="直線コネクタ 174"/>
                  <p:cNvCxnSpPr/>
                  <p:nvPr/>
                </p:nvCxnSpPr>
                <p:spPr>
                  <a:xfrm>
                    <a:off x="1685735" y="3800864"/>
                    <a:ext cx="5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6" name="直線コネクタ 175"/>
                  <p:cNvCxnSpPr/>
                  <p:nvPr/>
                </p:nvCxnSpPr>
                <p:spPr>
                  <a:xfrm>
                    <a:off x="1662546" y="2532122"/>
                    <a:ext cx="77189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7" name="直線コネクタ 176"/>
                  <p:cNvCxnSpPr/>
                  <p:nvPr/>
                </p:nvCxnSpPr>
                <p:spPr>
                  <a:xfrm>
                    <a:off x="1662546" y="3377950"/>
                    <a:ext cx="77189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8" name="直線コネクタ 177"/>
                  <p:cNvCxnSpPr/>
                  <p:nvPr/>
                </p:nvCxnSpPr>
                <p:spPr>
                  <a:xfrm>
                    <a:off x="1662546" y="4223782"/>
                    <a:ext cx="77189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62" name="テキスト ボックス 161"/>
                <p:cNvSpPr txBox="1"/>
                <p:nvPr/>
              </p:nvSpPr>
              <p:spPr>
                <a:xfrm>
                  <a:off x="632116" y="1462180"/>
                  <a:ext cx="355837" cy="4184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 smtClean="0">
                      <a:latin typeface="Arial"/>
                      <a:cs typeface="Arial"/>
                    </a:rPr>
                    <a:t>300</a:t>
                  </a:r>
                  <a:endParaRPr kumimoji="1" lang="ja-JP" alt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63" name="テキスト ボックス 162"/>
                <p:cNvSpPr txBox="1"/>
                <p:nvPr/>
              </p:nvSpPr>
              <p:spPr>
                <a:xfrm>
                  <a:off x="632116" y="2340106"/>
                  <a:ext cx="355837" cy="4184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 smtClean="0">
                      <a:latin typeface="Arial"/>
                      <a:cs typeface="Arial"/>
                    </a:rPr>
                    <a:t>200</a:t>
                  </a:r>
                  <a:endParaRPr kumimoji="1" lang="ja-JP" alt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64" name="テキスト ボックス 163"/>
                <p:cNvSpPr txBox="1"/>
                <p:nvPr/>
              </p:nvSpPr>
              <p:spPr>
                <a:xfrm>
                  <a:off x="632116" y="3193286"/>
                  <a:ext cx="355837" cy="4184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cs typeface="Arial"/>
                    </a:rPr>
                    <a:t>100</a:t>
                  </a:r>
                  <a:endParaRPr kumimoji="1" lang="ja-JP" alt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65" name="テキスト ボックス 164"/>
                <p:cNvSpPr txBox="1"/>
                <p:nvPr/>
              </p:nvSpPr>
              <p:spPr>
                <a:xfrm>
                  <a:off x="747532" y="4046467"/>
                  <a:ext cx="241723" cy="4184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 smtClean="0">
                      <a:latin typeface="Arial"/>
                      <a:cs typeface="Arial"/>
                    </a:rPr>
                    <a:t>0</a:t>
                  </a:r>
                  <a:endParaRPr kumimoji="1" lang="ja-JP" altLang="en-US" sz="8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79" name="グループ化 38"/>
              <p:cNvGrpSpPr>
                <a:grpSpLocks noChangeAspect="1"/>
              </p:cNvGrpSpPr>
              <p:nvPr/>
            </p:nvGrpSpPr>
            <p:grpSpPr>
              <a:xfrm>
                <a:off x="1344229" y="1890875"/>
                <a:ext cx="1315051" cy="37661"/>
                <a:chOff x="5852160" y="3933775"/>
                <a:chExt cx="2630103" cy="75322"/>
              </a:xfrm>
            </p:grpSpPr>
            <p:grpSp>
              <p:nvGrpSpPr>
                <p:cNvPr id="180" name="グループ化 83"/>
                <p:cNvGrpSpPr/>
                <p:nvPr/>
              </p:nvGrpSpPr>
              <p:grpSpPr>
                <a:xfrm>
                  <a:off x="5852160" y="3937786"/>
                  <a:ext cx="2569244" cy="71311"/>
                  <a:chOff x="5852160" y="3937786"/>
                  <a:chExt cx="2569244" cy="71311"/>
                </a:xfrm>
              </p:grpSpPr>
              <p:cxnSp>
                <p:nvCxnSpPr>
                  <p:cNvPr id="182" name="直線コネクタ 181"/>
                  <p:cNvCxnSpPr/>
                  <p:nvPr/>
                </p:nvCxnSpPr>
                <p:spPr>
                  <a:xfrm rot="16200000" flipH="1">
                    <a:off x="5816505" y="3973442"/>
                    <a:ext cx="7131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3" name="直線コネクタ 182"/>
                  <p:cNvCxnSpPr/>
                  <p:nvPr/>
                </p:nvCxnSpPr>
                <p:spPr>
                  <a:xfrm rot="16200000" flipH="1">
                    <a:off x="5960792" y="3959387"/>
                    <a:ext cx="432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4" name="直線コネクタ 183"/>
                  <p:cNvCxnSpPr/>
                  <p:nvPr/>
                </p:nvCxnSpPr>
                <p:spPr>
                  <a:xfrm rot="16200000" flipH="1">
                    <a:off x="587654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5" name="直線コネクタ 184"/>
                  <p:cNvCxnSpPr/>
                  <p:nvPr/>
                </p:nvCxnSpPr>
                <p:spPr>
                  <a:xfrm rot="16200000" flipH="1">
                    <a:off x="5857142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6" name="直線コネクタ 185"/>
                  <p:cNvCxnSpPr/>
                  <p:nvPr/>
                </p:nvCxnSpPr>
                <p:spPr>
                  <a:xfrm rot="16200000" flipH="1">
                    <a:off x="5912562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7" name="直線コネクタ 186"/>
                  <p:cNvCxnSpPr/>
                  <p:nvPr/>
                </p:nvCxnSpPr>
                <p:spPr>
                  <a:xfrm rot="16200000" flipH="1">
                    <a:off x="5940272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8" name="直線コネクタ 187"/>
                  <p:cNvCxnSpPr/>
                  <p:nvPr/>
                </p:nvCxnSpPr>
                <p:spPr>
                  <a:xfrm rot="16200000" flipH="1">
                    <a:off x="600123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9" name="直線コネクタ 188"/>
                  <p:cNvCxnSpPr/>
                  <p:nvPr/>
                </p:nvCxnSpPr>
                <p:spPr>
                  <a:xfrm rot="16200000" flipH="1">
                    <a:off x="602894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0" name="直線コネクタ 189"/>
                  <p:cNvCxnSpPr/>
                  <p:nvPr/>
                </p:nvCxnSpPr>
                <p:spPr>
                  <a:xfrm rot="16200000" flipH="1">
                    <a:off x="605665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1" name="直線コネクタ 190"/>
                  <p:cNvCxnSpPr/>
                  <p:nvPr/>
                </p:nvCxnSpPr>
                <p:spPr>
                  <a:xfrm rot="16200000" flipH="1">
                    <a:off x="6095448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2" name="直線コネクタ 191"/>
                  <p:cNvCxnSpPr/>
                  <p:nvPr/>
                </p:nvCxnSpPr>
                <p:spPr>
                  <a:xfrm rot="16200000" flipH="1">
                    <a:off x="608436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3" name="直線コネクタ 192"/>
                  <p:cNvCxnSpPr/>
                  <p:nvPr/>
                </p:nvCxnSpPr>
                <p:spPr>
                  <a:xfrm rot="16200000" flipH="1">
                    <a:off x="6100990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4" name="直線コネクタ 193"/>
                  <p:cNvCxnSpPr/>
                  <p:nvPr/>
                </p:nvCxnSpPr>
                <p:spPr>
                  <a:xfrm rot="16200000" flipH="1">
                    <a:off x="6203808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5" name="直線コネクタ 194"/>
                  <p:cNvCxnSpPr/>
                  <p:nvPr/>
                </p:nvCxnSpPr>
                <p:spPr>
                  <a:xfrm rot="16200000" flipH="1">
                    <a:off x="6233998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6" name="直線コネクタ 195"/>
                  <p:cNvCxnSpPr/>
                  <p:nvPr/>
                </p:nvCxnSpPr>
                <p:spPr>
                  <a:xfrm rot="16200000" flipH="1">
                    <a:off x="6311586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7" name="直線コネクタ 196"/>
                  <p:cNvCxnSpPr/>
                  <p:nvPr/>
                </p:nvCxnSpPr>
                <p:spPr>
                  <a:xfrm rot="16200000" flipH="1">
                    <a:off x="6285407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8" name="直線コネクタ 197"/>
                  <p:cNvCxnSpPr/>
                  <p:nvPr/>
                </p:nvCxnSpPr>
                <p:spPr>
                  <a:xfrm rot="16200000" flipH="1">
                    <a:off x="6357157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直線コネクタ 198"/>
                  <p:cNvCxnSpPr/>
                  <p:nvPr/>
                </p:nvCxnSpPr>
                <p:spPr>
                  <a:xfrm rot="16200000" flipH="1">
                    <a:off x="6336520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0" name="直線コネクタ 199"/>
                  <p:cNvCxnSpPr/>
                  <p:nvPr/>
                </p:nvCxnSpPr>
                <p:spPr>
                  <a:xfrm rot="16200000" flipH="1">
                    <a:off x="6563742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1" name="直線コネクタ 200"/>
                  <p:cNvCxnSpPr/>
                  <p:nvPr/>
                </p:nvCxnSpPr>
                <p:spPr>
                  <a:xfrm rot="16200000" flipH="1">
                    <a:off x="668012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2" name="直線コネクタ 201"/>
                  <p:cNvCxnSpPr/>
                  <p:nvPr/>
                </p:nvCxnSpPr>
                <p:spPr>
                  <a:xfrm rot="16200000" flipH="1">
                    <a:off x="676325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3" name="直線コネクタ 202"/>
                  <p:cNvCxnSpPr/>
                  <p:nvPr/>
                </p:nvCxnSpPr>
                <p:spPr>
                  <a:xfrm rot="16200000" flipH="1">
                    <a:off x="6919665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4" name="直線コネクタ 203"/>
                  <p:cNvCxnSpPr/>
                  <p:nvPr/>
                </p:nvCxnSpPr>
                <p:spPr>
                  <a:xfrm rot="16200000" flipH="1">
                    <a:off x="688794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5" name="直線コネクタ 204"/>
                  <p:cNvCxnSpPr/>
                  <p:nvPr/>
                </p:nvCxnSpPr>
                <p:spPr>
                  <a:xfrm rot="16200000" flipH="1">
                    <a:off x="6965532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6" name="直線コネクタ 205"/>
                  <p:cNvCxnSpPr/>
                  <p:nvPr/>
                </p:nvCxnSpPr>
                <p:spPr>
                  <a:xfrm rot="16200000" flipH="1">
                    <a:off x="699878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7" name="直線コネクタ 206"/>
                  <p:cNvCxnSpPr/>
                  <p:nvPr/>
                </p:nvCxnSpPr>
                <p:spPr>
                  <a:xfrm rot="16200000" flipH="1">
                    <a:off x="7212146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8" name="直線コネクタ 207"/>
                  <p:cNvCxnSpPr/>
                  <p:nvPr/>
                </p:nvCxnSpPr>
                <p:spPr>
                  <a:xfrm rot="16200000" flipH="1">
                    <a:off x="7322986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9" name="直線コネクタ 208"/>
                  <p:cNvCxnSpPr/>
                  <p:nvPr/>
                </p:nvCxnSpPr>
                <p:spPr>
                  <a:xfrm rot="16200000" flipH="1">
                    <a:off x="7399329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0" name="直線コネクタ 209"/>
                  <p:cNvCxnSpPr/>
                  <p:nvPr/>
                </p:nvCxnSpPr>
                <p:spPr>
                  <a:xfrm rot="16200000" flipH="1">
                    <a:off x="7503096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1" name="直線コネクタ 210"/>
                  <p:cNvCxnSpPr/>
                  <p:nvPr/>
                </p:nvCxnSpPr>
                <p:spPr>
                  <a:xfrm rot="16200000" flipH="1">
                    <a:off x="7600076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2" name="直線コネクタ 211"/>
                  <p:cNvCxnSpPr/>
                  <p:nvPr/>
                </p:nvCxnSpPr>
                <p:spPr>
                  <a:xfrm rot="16200000" flipH="1">
                    <a:off x="7583450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3" name="直線コネクタ 212"/>
                  <p:cNvCxnSpPr/>
                  <p:nvPr/>
                </p:nvCxnSpPr>
                <p:spPr>
                  <a:xfrm rot="16200000" flipH="1">
                    <a:off x="753911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4" name="直線コネクタ 213"/>
                  <p:cNvCxnSpPr/>
                  <p:nvPr/>
                </p:nvCxnSpPr>
                <p:spPr>
                  <a:xfrm rot="16200000" flipH="1">
                    <a:off x="7813438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5" name="直線コネクタ 214"/>
                  <p:cNvCxnSpPr/>
                  <p:nvPr/>
                </p:nvCxnSpPr>
                <p:spPr>
                  <a:xfrm rot="16200000" flipH="1">
                    <a:off x="7920267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6" name="直線コネクタ 215"/>
                  <p:cNvCxnSpPr/>
                  <p:nvPr/>
                </p:nvCxnSpPr>
                <p:spPr>
                  <a:xfrm rot="16200000" flipH="1">
                    <a:off x="7985526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7" name="直線コネクタ 216"/>
                  <p:cNvCxnSpPr/>
                  <p:nvPr/>
                </p:nvCxnSpPr>
                <p:spPr>
                  <a:xfrm rot="16200000" flipH="1">
                    <a:off x="8093304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8" name="直線コネクタ 217"/>
                  <p:cNvCxnSpPr/>
                  <p:nvPr/>
                </p:nvCxnSpPr>
                <p:spPr>
                  <a:xfrm rot="16200000" flipH="1">
                    <a:off x="8136395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" name="直線コネクタ 218"/>
                  <p:cNvCxnSpPr/>
                  <p:nvPr/>
                </p:nvCxnSpPr>
                <p:spPr>
                  <a:xfrm rot="16200000" flipH="1">
                    <a:off x="8173658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0" name="直線コネクタ 219"/>
                  <p:cNvCxnSpPr/>
                  <p:nvPr/>
                </p:nvCxnSpPr>
                <p:spPr>
                  <a:xfrm rot="16200000" flipH="1">
                    <a:off x="8198888" y="3952187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1" name="直線コネクタ 220"/>
                  <p:cNvCxnSpPr/>
                  <p:nvPr/>
                </p:nvCxnSpPr>
                <p:spPr>
                  <a:xfrm rot="16200000" flipH="1">
                    <a:off x="8407004" y="3952186"/>
                    <a:ext cx="288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" name="直線コネクタ 221"/>
                  <p:cNvCxnSpPr/>
                  <p:nvPr/>
                </p:nvCxnSpPr>
                <p:spPr>
                  <a:xfrm rot="16200000" flipH="1">
                    <a:off x="6057147" y="3973442"/>
                    <a:ext cx="7131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3" name="直線コネクタ 222"/>
                  <p:cNvCxnSpPr/>
                  <p:nvPr/>
                </p:nvCxnSpPr>
                <p:spPr>
                  <a:xfrm rot="16200000" flipH="1">
                    <a:off x="6089217" y="3973442"/>
                    <a:ext cx="7131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" name="直線コネクタ 223"/>
                  <p:cNvCxnSpPr/>
                  <p:nvPr/>
                </p:nvCxnSpPr>
                <p:spPr>
                  <a:xfrm rot="16200000" flipH="1">
                    <a:off x="6365976" y="3973442"/>
                    <a:ext cx="7131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5" name="直線コネクタ 224"/>
                  <p:cNvCxnSpPr/>
                  <p:nvPr/>
                </p:nvCxnSpPr>
                <p:spPr>
                  <a:xfrm rot="16200000" flipH="1">
                    <a:off x="7007718" y="3973442"/>
                    <a:ext cx="7131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6" name="直線コネクタ 225"/>
                  <p:cNvCxnSpPr/>
                  <p:nvPr/>
                </p:nvCxnSpPr>
                <p:spPr>
                  <a:xfrm rot="16200000" flipH="1">
                    <a:off x="7608404" y="3973442"/>
                    <a:ext cx="7131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" name="直線コネクタ 226"/>
                  <p:cNvCxnSpPr/>
                  <p:nvPr/>
                </p:nvCxnSpPr>
                <p:spPr>
                  <a:xfrm rot="16200000" flipH="1">
                    <a:off x="8201699" y="3973442"/>
                    <a:ext cx="7131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8" name="直線コネクタ 227"/>
                  <p:cNvCxnSpPr/>
                  <p:nvPr/>
                </p:nvCxnSpPr>
                <p:spPr>
                  <a:xfrm rot="16200000" flipH="1">
                    <a:off x="6253577" y="3959387"/>
                    <a:ext cx="432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" name="直線コネクタ 228"/>
                  <p:cNvCxnSpPr/>
                  <p:nvPr/>
                </p:nvCxnSpPr>
                <p:spPr>
                  <a:xfrm rot="16200000" flipH="1">
                    <a:off x="6827150" y="3959387"/>
                    <a:ext cx="432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0" name="直線コネクタ 229"/>
                  <p:cNvCxnSpPr/>
                  <p:nvPr/>
                </p:nvCxnSpPr>
                <p:spPr>
                  <a:xfrm rot="16200000" flipH="1">
                    <a:off x="7446000" y="3959387"/>
                    <a:ext cx="432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1" name="直線コネクタ 230"/>
                  <p:cNvCxnSpPr/>
                  <p:nvPr/>
                </p:nvCxnSpPr>
                <p:spPr>
                  <a:xfrm rot="16200000" flipH="1">
                    <a:off x="8043621" y="3959387"/>
                    <a:ext cx="432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81" name="直線コネクタ 180"/>
                <p:cNvCxnSpPr/>
                <p:nvPr/>
              </p:nvCxnSpPr>
              <p:spPr>
                <a:xfrm>
                  <a:off x="5852160" y="3933775"/>
                  <a:ext cx="2630103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32" name="テキスト ボックス 231"/>
            <p:cNvSpPr txBox="1"/>
            <p:nvPr/>
          </p:nvSpPr>
          <p:spPr>
            <a:xfrm>
              <a:off x="1732726" y="2036280"/>
              <a:ext cx="2143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33" name="テキスト ボックス 232"/>
            <p:cNvSpPr txBox="1"/>
            <p:nvPr/>
          </p:nvSpPr>
          <p:spPr>
            <a:xfrm>
              <a:off x="1927381" y="2036280"/>
              <a:ext cx="204790" cy="21544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cs typeface="Arial"/>
                </a:rPr>
                <a:t>1</a:t>
              </a:r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r>
                <a:rPr kumimoji="1" lang="en-US" altLang="ja-JP" sz="800" baseline="30000" dirty="0" smtClean="0">
                  <a:latin typeface="Arial"/>
                  <a:cs typeface="Arial"/>
                </a:rPr>
                <a:t>2</a:t>
              </a:r>
              <a:endParaRPr kumimoji="1" lang="ja-JP" alt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234" name="テキスト ボックス 233"/>
            <p:cNvSpPr txBox="1"/>
            <p:nvPr/>
          </p:nvSpPr>
          <p:spPr>
            <a:xfrm>
              <a:off x="2242316" y="2036280"/>
              <a:ext cx="204790" cy="21544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cs typeface="Arial"/>
                </a:rPr>
                <a:t>1</a:t>
              </a:r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r>
                <a:rPr lang="en-US" altLang="ja-JP" sz="800" baseline="30000" dirty="0" smtClean="0">
                  <a:latin typeface="Arial"/>
                  <a:cs typeface="Arial"/>
                </a:rPr>
                <a:t>3</a:t>
              </a:r>
              <a:endParaRPr kumimoji="1" lang="ja-JP" alt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235" name="テキスト ボックス 234"/>
            <p:cNvSpPr txBox="1"/>
            <p:nvPr/>
          </p:nvSpPr>
          <p:spPr>
            <a:xfrm>
              <a:off x="2547524" y="2036280"/>
              <a:ext cx="204790" cy="21544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cs typeface="Arial"/>
                </a:rPr>
                <a:t>1</a:t>
              </a:r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r>
                <a:rPr lang="en-US" altLang="ja-JP" sz="800" baseline="30000" dirty="0" smtClean="0">
                  <a:latin typeface="Arial"/>
                  <a:cs typeface="Arial"/>
                </a:rPr>
                <a:t>4</a:t>
              </a:r>
              <a:endParaRPr kumimoji="1" lang="ja-JP" alt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236" name="テキスト ボックス 235"/>
            <p:cNvSpPr txBox="1"/>
            <p:nvPr/>
          </p:nvSpPr>
          <p:spPr>
            <a:xfrm>
              <a:off x="2846347" y="2036280"/>
              <a:ext cx="204790" cy="21544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cs typeface="Arial"/>
                </a:rPr>
                <a:t>1</a:t>
              </a:r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r>
                <a:rPr lang="en-US" altLang="ja-JP" sz="800" baseline="30000" dirty="0" smtClean="0">
                  <a:latin typeface="Arial"/>
                  <a:cs typeface="Arial"/>
                </a:rPr>
                <a:t>5</a:t>
              </a:r>
              <a:endParaRPr kumimoji="1" lang="ja-JP" altLang="en-US" sz="800" baseline="30000" dirty="0">
                <a:latin typeface="Arial"/>
                <a:cs typeface="Arial"/>
              </a:endParaRPr>
            </a:p>
          </p:txBody>
        </p:sp>
        <p:grpSp>
          <p:nvGrpSpPr>
            <p:cNvPr id="2" name="図形グループ 1"/>
            <p:cNvGrpSpPr/>
            <p:nvPr/>
          </p:nvGrpSpPr>
          <p:grpSpPr>
            <a:xfrm>
              <a:off x="3789040" y="717436"/>
              <a:ext cx="1595404" cy="1524890"/>
              <a:chOff x="2647513" y="569578"/>
              <a:chExt cx="1595404" cy="1524890"/>
            </a:xfrm>
          </p:grpSpPr>
          <p:grpSp>
            <p:nvGrpSpPr>
              <p:cNvPr id="150" name="グループ化 8"/>
              <p:cNvGrpSpPr>
                <a:grpSpLocks noChangeAspect="1"/>
              </p:cNvGrpSpPr>
              <p:nvPr/>
            </p:nvGrpSpPr>
            <p:grpSpPr>
              <a:xfrm>
                <a:off x="2906691" y="569578"/>
                <a:ext cx="1321130" cy="1321831"/>
                <a:chOff x="1484416" y="2238499"/>
                <a:chExt cx="2642259" cy="2643662"/>
              </a:xfrm>
            </p:grpSpPr>
            <p:sp>
              <p:nvSpPr>
                <p:cNvPr id="151" name="フリーフォーム 150"/>
                <p:cNvSpPr/>
                <p:nvPr/>
              </p:nvSpPr>
              <p:spPr>
                <a:xfrm>
                  <a:off x="2304716" y="2395621"/>
                  <a:ext cx="320945" cy="2486540"/>
                </a:xfrm>
                <a:custGeom>
                  <a:avLst/>
                  <a:gdLst>
                    <a:gd name="connsiteX0" fmla="*/ 310147 w 320945"/>
                    <a:gd name="connsiteY0" fmla="*/ 0 h 2486540"/>
                    <a:gd name="connsiteX1" fmla="*/ 320842 w 320945"/>
                    <a:gd name="connsiteY1" fmla="*/ 26737 h 2486540"/>
                    <a:gd name="connsiteX2" fmla="*/ 304800 w 320945"/>
                    <a:gd name="connsiteY2" fmla="*/ 58821 h 2486540"/>
                    <a:gd name="connsiteX3" fmla="*/ 294105 w 320945"/>
                    <a:gd name="connsiteY3" fmla="*/ 90905 h 2486540"/>
                    <a:gd name="connsiteX4" fmla="*/ 283410 w 320945"/>
                    <a:gd name="connsiteY4" fmla="*/ 128337 h 2486540"/>
                    <a:gd name="connsiteX5" fmla="*/ 262021 w 320945"/>
                    <a:gd name="connsiteY5" fmla="*/ 122990 h 2486540"/>
                    <a:gd name="connsiteX6" fmla="*/ 245979 w 320945"/>
                    <a:gd name="connsiteY6" fmla="*/ 176463 h 2486540"/>
                    <a:gd name="connsiteX7" fmla="*/ 235284 w 320945"/>
                    <a:gd name="connsiteY7" fmla="*/ 208547 h 2486540"/>
                    <a:gd name="connsiteX8" fmla="*/ 240631 w 320945"/>
                    <a:gd name="connsiteY8" fmla="*/ 256674 h 2486540"/>
                    <a:gd name="connsiteX9" fmla="*/ 229937 w 320945"/>
                    <a:gd name="connsiteY9" fmla="*/ 358274 h 2486540"/>
                    <a:gd name="connsiteX10" fmla="*/ 224589 w 320945"/>
                    <a:gd name="connsiteY10" fmla="*/ 486611 h 2486540"/>
                    <a:gd name="connsiteX11" fmla="*/ 224589 w 320945"/>
                    <a:gd name="connsiteY11" fmla="*/ 540084 h 2486540"/>
                    <a:gd name="connsiteX12" fmla="*/ 219242 w 320945"/>
                    <a:gd name="connsiteY12" fmla="*/ 695158 h 2486540"/>
                    <a:gd name="connsiteX13" fmla="*/ 208547 w 320945"/>
                    <a:gd name="connsiteY13" fmla="*/ 711200 h 2486540"/>
                    <a:gd name="connsiteX14" fmla="*/ 219242 w 320945"/>
                    <a:gd name="connsiteY14" fmla="*/ 807453 h 2486540"/>
                    <a:gd name="connsiteX15" fmla="*/ 213895 w 320945"/>
                    <a:gd name="connsiteY15" fmla="*/ 1064126 h 2486540"/>
                    <a:gd name="connsiteX16" fmla="*/ 208547 w 320945"/>
                    <a:gd name="connsiteY16" fmla="*/ 1080168 h 2486540"/>
                    <a:gd name="connsiteX17" fmla="*/ 213895 w 320945"/>
                    <a:gd name="connsiteY17" fmla="*/ 1197811 h 2486540"/>
                    <a:gd name="connsiteX18" fmla="*/ 208547 w 320945"/>
                    <a:gd name="connsiteY18" fmla="*/ 1379621 h 2486540"/>
                    <a:gd name="connsiteX19" fmla="*/ 197852 w 320945"/>
                    <a:gd name="connsiteY19" fmla="*/ 1411705 h 2486540"/>
                    <a:gd name="connsiteX20" fmla="*/ 197852 w 320945"/>
                    <a:gd name="connsiteY20" fmla="*/ 1598863 h 2486540"/>
                    <a:gd name="connsiteX21" fmla="*/ 192505 w 320945"/>
                    <a:gd name="connsiteY21" fmla="*/ 1614905 h 2486540"/>
                    <a:gd name="connsiteX22" fmla="*/ 187158 w 320945"/>
                    <a:gd name="connsiteY22" fmla="*/ 1732547 h 2486540"/>
                    <a:gd name="connsiteX23" fmla="*/ 181810 w 320945"/>
                    <a:gd name="connsiteY23" fmla="*/ 1748590 h 2486540"/>
                    <a:gd name="connsiteX24" fmla="*/ 176463 w 320945"/>
                    <a:gd name="connsiteY24" fmla="*/ 1919705 h 2486540"/>
                    <a:gd name="connsiteX25" fmla="*/ 165768 w 320945"/>
                    <a:gd name="connsiteY25" fmla="*/ 1978526 h 2486540"/>
                    <a:gd name="connsiteX26" fmla="*/ 171116 w 320945"/>
                    <a:gd name="connsiteY26" fmla="*/ 2096168 h 2486540"/>
                    <a:gd name="connsiteX27" fmla="*/ 165768 w 320945"/>
                    <a:gd name="connsiteY27" fmla="*/ 2117558 h 2486540"/>
                    <a:gd name="connsiteX28" fmla="*/ 155073 w 320945"/>
                    <a:gd name="connsiteY28" fmla="*/ 2176379 h 2486540"/>
                    <a:gd name="connsiteX29" fmla="*/ 149726 w 320945"/>
                    <a:gd name="connsiteY29" fmla="*/ 2203116 h 2486540"/>
                    <a:gd name="connsiteX30" fmla="*/ 144379 w 320945"/>
                    <a:gd name="connsiteY30" fmla="*/ 2272632 h 2486540"/>
                    <a:gd name="connsiteX31" fmla="*/ 133684 w 320945"/>
                    <a:gd name="connsiteY31" fmla="*/ 2304716 h 2486540"/>
                    <a:gd name="connsiteX32" fmla="*/ 122989 w 320945"/>
                    <a:gd name="connsiteY32" fmla="*/ 2384926 h 2486540"/>
                    <a:gd name="connsiteX33" fmla="*/ 106947 w 320945"/>
                    <a:gd name="connsiteY33" fmla="*/ 2417011 h 2486540"/>
                    <a:gd name="connsiteX34" fmla="*/ 85558 w 320945"/>
                    <a:gd name="connsiteY34" fmla="*/ 2427705 h 2486540"/>
                    <a:gd name="connsiteX35" fmla="*/ 74863 w 320945"/>
                    <a:gd name="connsiteY35" fmla="*/ 2443747 h 2486540"/>
                    <a:gd name="connsiteX36" fmla="*/ 69516 w 320945"/>
                    <a:gd name="connsiteY36" fmla="*/ 2459790 h 2486540"/>
                    <a:gd name="connsiteX37" fmla="*/ 21389 w 320945"/>
                    <a:gd name="connsiteY37" fmla="*/ 2481179 h 2486540"/>
                    <a:gd name="connsiteX38" fmla="*/ 0 w 320945"/>
                    <a:gd name="connsiteY38" fmla="*/ 2486526 h 24865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</a:cxnLst>
                  <a:rect l="l" t="t" r="r" b="b"/>
                  <a:pathLst>
                    <a:path w="320945" h="2486540">
                      <a:moveTo>
                        <a:pt x="310147" y="0"/>
                      </a:moveTo>
                      <a:cubicBezTo>
                        <a:pt x="313712" y="8912"/>
                        <a:pt x="319651" y="17212"/>
                        <a:pt x="320842" y="26737"/>
                      </a:cubicBezTo>
                      <a:cubicBezTo>
                        <a:pt x="322269" y="38154"/>
                        <a:pt x="308581" y="50315"/>
                        <a:pt x="304800" y="58821"/>
                      </a:cubicBezTo>
                      <a:cubicBezTo>
                        <a:pt x="300221" y="69123"/>
                        <a:pt x="297670" y="80210"/>
                        <a:pt x="294105" y="90905"/>
                      </a:cubicBezTo>
                      <a:cubicBezTo>
                        <a:pt x="286435" y="113914"/>
                        <a:pt x="290123" y="101486"/>
                        <a:pt x="283410" y="128337"/>
                      </a:cubicBezTo>
                      <a:cubicBezTo>
                        <a:pt x="276280" y="126555"/>
                        <a:pt x="268993" y="120666"/>
                        <a:pt x="262021" y="122990"/>
                      </a:cubicBezTo>
                      <a:cubicBezTo>
                        <a:pt x="247366" y="127875"/>
                        <a:pt x="246290" y="175116"/>
                        <a:pt x="245979" y="176463"/>
                      </a:cubicBezTo>
                      <a:cubicBezTo>
                        <a:pt x="243444" y="187448"/>
                        <a:pt x="235284" y="208547"/>
                        <a:pt x="235284" y="208547"/>
                      </a:cubicBezTo>
                      <a:cubicBezTo>
                        <a:pt x="237066" y="224589"/>
                        <a:pt x="240631" y="240533"/>
                        <a:pt x="240631" y="256674"/>
                      </a:cubicBezTo>
                      <a:cubicBezTo>
                        <a:pt x="240631" y="310628"/>
                        <a:pt x="238012" y="317894"/>
                        <a:pt x="229937" y="358274"/>
                      </a:cubicBezTo>
                      <a:cubicBezTo>
                        <a:pt x="228154" y="401053"/>
                        <a:pt x="227752" y="443912"/>
                        <a:pt x="224589" y="486611"/>
                      </a:cubicBezTo>
                      <a:cubicBezTo>
                        <a:pt x="220036" y="548070"/>
                        <a:pt x="207757" y="422254"/>
                        <a:pt x="224589" y="540084"/>
                      </a:cubicBezTo>
                      <a:cubicBezTo>
                        <a:pt x="222807" y="591775"/>
                        <a:pt x="224070" y="643662"/>
                        <a:pt x="219242" y="695158"/>
                      </a:cubicBezTo>
                      <a:cubicBezTo>
                        <a:pt x="218642" y="701557"/>
                        <a:pt x="208924" y="704784"/>
                        <a:pt x="208547" y="711200"/>
                      </a:cubicBezTo>
                      <a:cubicBezTo>
                        <a:pt x="205752" y="758723"/>
                        <a:pt x="210374" y="771977"/>
                        <a:pt x="219242" y="807453"/>
                      </a:cubicBezTo>
                      <a:cubicBezTo>
                        <a:pt x="217460" y="893011"/>
                        <a:pt x="217248" y="978616"/>
                        <a:pt x="213895" y="1064126"/>
                      </a:cubicBezTo>
                      <a:cubicBezTo>
                        <a:pt x="213674" y="1069758"/>
                        <a:pt x="208547" y="1074531"/>
                        <a:pt x="208547" y="1080168"/>
                      </a:cubicBezTo>
                      <a:cubicBezTo>
                        <a:pt x="208547" y="1119423"/>
                        <a:pt x="212112" y="1158597"/>
                        <a:pt x="213895" y="1197811"/>
                      </a:cubicBezTo>
                      <a:cubicBezTo>
                        <a:pt x="212112" y="1258414"/>
                        <a:pt x="213082" y="1319161"/>
                        <a:pt x="208547" y="1379621"/>
                      </a:cubicBezTo>
                      <a:cubicBezTo>
                        <a:pt x="207704" y="1390863"/>
                        <a:pt x="197852" y="1411705"/>
                        <a:pt x="197852" y="1411705"/>
                      </a:cubicBezTo>
                      <a:cubicBezTo>
                        <a:pt x="203965" y="1503386"/>
                        <a:pt x="206683" y="1497314"/>
                        <a:pt x="197852" y="1598863"/>
                      </a:cubicBezTo>
                      <a:cubicBezTo>
                        <a:pt x="197364" y="1604478"/>
                        <a:pt x="194287" y="1609558"/>
                        <a:pt x="192505" y="1614905"/>
                      </a:cubicBezTo>
                      <a:cubicBezTo>
                        <a:pt x="190723" y="1654119"/>
                        <a:pt x="190288" y="1693418"/>
                        <a:pt x="187158" y="1732547"/>
                      </a:cubicBezTo>
                      <a:cubicBezTo>
                        <a:pt x="186708" y="1738166"/>
                        <a:pt x="182132" y="1742962"/>
                        <a:pt x="181810" y="1748590"/>
                      </a:cubicBezTo>
                      <a:cubicBezTo>
                        <a:pt x="178554" y="1805563"/>
                        <a:pt x="179313" y="1862710"/>
                        <a:pt x="176463" y="1919705"/>
                      </a:cubicBezTo>
                      <a:cubicBezTo>
                        <a:pt x="174685" y="1955276"/>
                        <a:pt x="173987" y="1953872"/>
                        <a:pt x="165768" y="1978526"/>
                      </a:cubicBezTo>
                      <a:cubicBezTo>
                        <a:pt x="167551" y="2017740"/>
                        <a:pt x="171116" y="2056914"/>
                        <a:pt x="171116" y="2096168"/>
                      </a:cubicBezTo>
                      <a:cubicBezTo>
                        <a:pt x="171116" y="2103517"/>
                        <a:pt x="167362" y="2110384"/>
                        <a:pt x="165768" y="2117558"/>
                      </a:cubicBezTo>
                      <a:cubicBezTo>
                        <a:pt x="159170" y="2147248"/>
                        <a:pt x="160871" y="2144490"/>
                        <a:pt x="155073" y="2176379"/>
                      </a:cubicBezTo>
                      <a:cubicBezTo>
                        <a:pt x="153447" y="2185321"/>
                        <a:pt x="151508" y="2194204"/>
                        <a:pt x="149726" y="2203116"/>
                      </a:cubicBezTo>
                      <a:cubicBezTo>
                        <a:pt x="147944" y="2226288"/>
                        <a:pt x="148004" y="2249676"/>
                        <a:pt x="144379" y="2272632"/>
                      </a:cubicBezTo>
                      <a:cubicBezTo>
                        <a:pt x="142621" y="2283767"/>
                        <a:pt x="133684" y="2304716"/>
                        <a:pt x="133684" y="2304716"/>
                      </a:cubicBezTo>
                      <a:cubicBezTo>
                        <a:pt x="130342" y="2338142"/>
                        <a:pt x="130375" y="2355384"/>
                        <a:pt x="122989" y="2384926"/>
                      </a:cubicBezTo>
                      <a:cubicBezTo>
                        <a:pt x="120491" y="2394916"/>
                        <a:pt x="115202" y="2410132"/>
                        <a:pt x="106947" y="2417011"/>
                      </a:cubicBezTo>
                      <a:cubicBezTo>
                        <a:pt x="100823" y="2422114"/>
                        <a:pt x="92688" y="2424140"/>
                        <a:pt x="85558" y="2427705"/>
                      </a:cubicBezTo>
                      <a:cubicBezTo>
                        <a:pt x="81993" y="2433052"/>
                        <a:pt x="77737" y="2437999"/>
                        <a:pt x="74863" y="2443747"/>
                      </a:cubicBezTo>
                      <a:cubicBezTo>
                        <a:pt x="72342" y="2448789"/>
                        <a:pt x="73037" y="2455388"/>
                        <a:pt x="69516" y="2459790"/>
                      </a:cubicBezTo>
                      <a:cubicBezTo>
                        <a:pt x="60274" y="2471343"/>
                        <a:pt x="31188" y="2477913"/>
                        <a:pt x="21389" y="2481179"/>
                      </a:cubicBezTo>
                      <a:cubicBezTo>
                        <a:pt x="3657" y="2487090"/>
                        <a:pt x="10983" y="2486526"/>
                        <a:pt x="0" y="2486526"/>
                      </a:cubicBezTo>
                    </a:path>
                  </a:pathLst>
                </a:custGeom>
                <a:noFill/>
                <a:ln w="635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/>
                    <a:cs typeface="Arial"/>
                  </a:endParaRPr>
                </a:p>
              </p:txBody>
            </p:sp>
            <p:sp>
              <p:nvSpPr>
                <p:cNvPr id="152" name="フリーフォーム 151"/>
                <p:cNvSpPr/>
                <p:nvPr/>
              </p:nvSpPr>
              <p:spPr>
                <a:xfrm>
                  <a:off x="2620211" y="2395621"/>
                  <a:ext cx="1187115" cy="2481179"/>
                </a:xfrm>
                <a:custGeom>
                  <a:avLst/>
                  <a:gdLst>
                    <a:gd name="connsiteX0" fmla="*/ 5347 w 1187115"/>
                    <a:gd name="connsiteY0" fmla="*/ 0 h 2481179"/>
                    <a:gd name="connsiteX1" fmla="*/ 0 w 1187115"/>
                    <a:gd name="connsiteY1" fmla="*/ 26737 h 2481179"/>
                    <a:gd name="connsiteX2" fmla="*/ 5347 w 1187115"/>
                    <a:gd name="connsiteY2" fmla="*/ 53474 h 2481179"/>
                    <a:gd name="connsiteX3" fmla="*/ 16042 w 1187115"/>
                    <a:gd name="connsiteY3" fmla="*/ 85558 h 2481179"/>
                    <a:gd name="connsiteX4" fmla="*/ 21389 w 1187115"/>
                    <a:gd name="connsiteY4" fmla="*/ 106947 h 2481179"/>
                    <a:gd name="connsiteX5" fmla="*/ 26736 w 1187115"/>
                    <a:gd name="connsiteY5" fmla="*/ 176463 h 2481179"/>
                    <a:gd name="connsiteX6" fmla="*/ 32084 w 1187115"/>
                    <a:gd name="connsiteY6" fmla="*/ 256674 h 2481179"/>
                    <a:gd name="connsiteX7" fmla="*/ 42778 w 1187115"/>
                    <a:gd name="connsiteY7" fmla="*/ 288758 h 2481179"/>
                    <a:gd name="connsiteX8" fmla="*/ 48126 w 1187115"/>
                    <a:gd name="connsiteY8" fmla="*/ 315495 h 2481179"/>
                    <a:gd name="connsiteX9" fmla="*/ 58821 w 1187115"/>
                    <a:gd name="connsiteY9" fmla="*/ 465221 h 2481179"/>
                    <a:gd name="connsiteX10" fmla="*/ 69515 w 1187115"/>
                    <a:gd name="connsiteY10" fmla="*/ 663074 h 2481179"/>
                    <a:gd name="connsiteX11" fmla="*/ 85557 w 1187115"/>
                    <a:gd name="connsiteY11" fmla="*/ 630990 h 2481179"/>
                    <a:gd name="connsiteX12" fmla="*/ 90905 w 1187115"/>
                    <a:gd name="connsiteY12" fmla="*/ 652379 h 2481179"/>
                    <a:gd name="connsiteX13" fmla="*/ 106947 w 1187115"/>
                    <a:gd name="connsiteY13" fmla="*/ 711200 h 2481179"/>
                    <a:gd name="connsiteX14" fmla="*/ 117642 w 1187115"/>
                    <a:gd name="connsiteY14" fmla="*/ 689811 h 2481179"/>
                    <a:gd name="connsiteX15" fmla="*/ 122989 w 1187115"/>
                    <a:gd name="connsiteY15" fmla="*/ 668421 h 2481179"/>
                    <a:gd name="connsiteX16" fmla="*/ 133684 w 1187115"/>
                    <a:gd name="connsiteY16" fmla="*/ 796758 h 2481179"/>
                    <a:gd name="connsiteX17" fmla="*/ 139031 w 1187115"/>
                    <a:gd name="connsiteY17" fmla="*/ 812800 h 2481179"/>
                    <a:gd name="connsiteX18" fmla="*/ 139031 w 1187115"/>
                    <a:gd name="connsiteY18" fmla="*/ 914400 h 2481179"/>
                    <a:gd name="connsiteX19" fmla="*/ 149726 w 1187115"/>
                    <a:gd name="connsiteY19" fmla="*/ 962526 h 2481179"/>
                    <a:gd name="connsiteX20" fmla="*/ 176463 w 1187115"/>
                    <a:gd name="connsiteY20" fmla="*/ 941137 h 2481179"/>
                    <a:gd name="connsiteX21" fmla="*/ 187157 w 1187115"/>
                    <a:gd name="connsiteY21" fmla="*/ 973221 h 2481179"/>
                    <a:gd name="connsiteX22" fmla="*/ 192505 w 1187115"/>
                    <a:gd name="connsiteY22" fmla="*/ 989263 h 2481179"/>
                    <a:gd name="connsiteX23" fmla="*/ 197852 w 1187115"/>
                    <a:gd name="connsiteY23" fmla="*/ 1005305 h 2481179"/>
                    <a:gd name="connsiteX24" fmla="*/ 208547 w 1187115"/>
                    <a:gd name="connsiteY24" fmla="*/ 1021347 h 2481179"/>
                    <a:gd name="connsiteX25" fmla="*/ 213894 w 1187115"/>
                    <a:gd name="connsiteY25" fmla="*/ 1005305 h 2481179"/>
                    <a:gd name="connsiteX26" fmla="*/ 219242 w 1187115"/>
                    <a:gd name="connsiteY26" fmla="*/ 930442 h 2481179"/>
                    <a:gd name="connsiteX27" fmla="*/ 235284 w 1187115"/>
                    <a:gd name="connsiteY27" fmla="*/ 935790 h 2481179"/>
                    <a:gd name="connsiteX28" fmla="*/ 262021 w 1187115"/>
                    <a:gd name="connsiteY28" fmla="*/ 909053 h 2481179"/>
                    <a:gd name="connsiteX29" fmla="*/ 256673 w 1187115"/>
                    <a:gd name="connsiteY29" fmla="*/ 882316 h 2481179"/>
                    <a:gd name="connsiteX30" fmla="*/ 262021 w 1187115"/>
                    <a:gd name="connsiteY30" fmla="*/ 802105 h 2481179"/>
                    <a:gd name="connsiteX31" fmla="*/ 272715 w 1187115"/>
                    <a:gd name="connsiteY31" fmla="*/ 786063 h 2481179"/>
                    <a:gd name="connsiteX32" fmla="*/ 278063 w 1187115"/>
                    <a:gd name="connsiteY32" fmla="*/ 770021 h 2481179"/>
                    <a:gd name="connsiteX33" fmla="*/ 288757 w 1187115"/>
                    <a:gd name="connsiteY33" fmla="*/ 802105 h 2481179"/>
                    <a:gd name="connsiteX34" fmla="*/ 294105 w 1187115"/>
                    <a:gd name="connsiteY34" fmla="*/ 818147 h 2481179"/>
                    <a:gd name="connsiteX35" fmla="*/ 299452 w 1187115"/>
                    <a:gd name="connsiteY35" fmla="*/ 882316 h 2481179"/>
                    <a:gd name="connsiteX36" fmla="*/ 310147 w 1187115"/>
                    <a:gd name="connsiteY36" fmla="*/ 973221 h 2481179"/>
                    <a:gd name="connsiteX37" fmla="*/ 315494 w 1187115"/>
                    <a:gd name="connsiteY37" fmla="*/ 1096211 h 2481179"/>
                    <a:gd name="connsiteX38" fmla="*/ 320842 w 1187115"/>
                    <a:gd name="connsiteY38" fmla="*/ 1112253 h 2481179"/>
                    <a:gd name="connsiteX39" fmla="*/ 326189 w 1187115"/>
                    <a:gd name="connsiteY39" fmla="*/ 1208505 h 2481179"/>
                    <a:gd name="connsiteX40" fmla="*/ 336884 w 1187115"/>
                    <a:gd name="connsiteY40" fmla="*/ 1288716 h 2481179"/>
                    <a:gd name="connsiteX41" fmla="*/ 342231 w 1187115"/>
                    <a:gd name="connsiteY41" fmla="*/ 1384968 h 2481179"/>
                    <a:gd name="connsiteX42" fmla="*/ 347578 w 1187115"/>
                    <a:gd name="connsiteY42" fmla="*/ 1406358 h 2481179"/>
                    <a:gd name="connsiteX43" fmla="*/ 352926 w 1187115"/>
                    <a:gd name="connsiteY43" fmla="*/ 1673726 h 2481179"/>
                    <a:gd name="connsiteX44" fmla="*/ 358273 w 1187115"/>
                    <a:gd name="connsiteY44" fmla="*/ 1689768 h 2481179"/>
                    <a:gd name="connsiteX45" fmla="*/ 363621 w 1187115"/>
                    <a:gd name="connsiteY45" fmla="*/ 1716505 h 2481179"/>
                    <a:gd name="connsiteX46" fmla="*/ 368968 w 1187115"/>
                    <a:gd name="connsiteY46" fmla="*/ 1834147 h 2481179"/>
                    <a:gd name="connsiteX47" fmla="*/ 379663 w 1187115"/>
                    <a:gd name="connsiteY47" fmla="*/ 1866232 h 2481179"/>
                    <a:gd name="connsiteX48" fmla="*/ 385010 w 1187115"/>
                    <a:gd name="connsiteY48" fmla="*/ 1882274 h 2481179"/>
                    <a:gd name="connsiteX49" fmla="*/ 401052 w 1187115"/>
                    <a:gd name="connsiteY49" fmla="*/ 1967832 h 2481179"/>
                    <a:gd name="connsiteX50" fmla="*/ 406400 w 1187115"/>
                    <a:gd name="connsiteY50" fmla="*/ 1989221 h 2481179"/>
                    <a:gd name="connsiteX51" fmla="*/ 417094 w 1187115"/>
                    <a:gd name="connsiteY51" fmla="*/ 2021305 h 2481179"/>
                    <a:gd name="connsiteX52" fmla="*/ 427789 w 1187115"/>
                    <a:gd name="connsiteY52" fmla="*/ 2117558 h 2481179"/>
                    <a:gd name="connsiteX53" fmla="*/ 438484 w 1187115"/>
                    <a:gd name="connsiteY53" fmla="*/ 2149642 h 2481179"/>
                    <a:gd name="connsiteX54" fmla="*/ 449178 w 1187115"/>
                    <a:gd name="connsiteY54" fmla="*/ 2165684 h 2481179"/>
                    <a:gd name="connsiteX55" fmla="*/ 454526 w 1187115"/>
                    <a:gd name="connsiteY55" fmla="*/ 2181726 h 2481179"/>
                    <a:gd name="connsiteX56" fmla="*/ 486610 w 1187115"/>
                    <a:gd name="connsiteY56" fmla="*/ 2203116 h 2481179"/>
                    <a:gd name="connsiteX57" fmla="*/ 513347 w 1187115"/>
                    <a:gd name="connsiteY57" fmla="*/ 2235200 h 2481179"/>
                    <a:gd name="connsiteX58" fmla="*/ 534736 w 1187115"/>
                    <a:gd name="connsiteY58" fmla="*/ 2267284 h 2481179"/>
                    <a:gd name="connsiteX59" fmla="*/ 545431 w 1187115"/>
                    <a:gd name="connsiteY59" fmla="*/ 2283326 h 2481179"/>
                    <a:gd name="connsiteX60" fmla="*/ 561473 w 1187115"/>
                    <a:gd name="connsiteY60" fmla="*/ 2294021 h 2481179"/>
                    <a:gd name="connsiteX61" fmla="*/ 609600 w 1187115"/>
                    <a:gd name="connsiteY61" fmla="*/ 2331453 h 2481179"/>
                    <a:gd name="connsiteX62" fmla="*/ 647031 w 1187115"/>
                    <a:gd name="connsiteY62" fmla="*/ 2336800 h 2481179"/>
                    <a:gd name="connsiteX63" fmla="*/ 716547 w 1187115"/>
                    <a:gd name="connsiteY63" fmla="*/ 2352842 h 2481179"/>
                    <a:gd name="connsiteX64" fmla="*/ 732589 w 1187115"/>
                    <a:gd name="connsiteY64" fmla="*/ 2358190 h 2481179"/>
                    <a:gd name="connsiteX65" fmla="*/ 818147 w 1187115"/>
                    <a:gd name="connsiteY65" fmla="*/ 2363537 h 2481179"/>
                    <a:gd name="connsiteX66" fmla="*/ 850231 w 1187115"/>
                    <a:gd name="connsiteY66" fmla="*/ 2384926 h 2481179"/>
                    <a:gd name="connsiteX67" fmla="*/ 882315 w 1187115"/>
                    <a:gd name="connsiteY67" fmla="*/ 2390274 h 2481179"/>
                    <a:gd name="connsiteX68" fmla="*/ 914400 w 1187115"/>
                    <a:gd name="connsiteY68" fmla="*/ 2411663 h 2481179"/>
                    <a:gd name="connsiteX69" fmla="*/ 930442 w 1187115"/>
                    <a:gd name="connsiteY69" fmla="*/ 2422358 h 2481179"/>
                    <a:gd name="connsiteX70" fmla="*/ 957178 w 1187115"/>
                    <a:gd name="connsiteY70" fmla="*/ 2427705 h 2481179"/>
                    <a:gd name="connsiteX71" fmla="*/ 989263 w 1187115"/>
                    <a:gd name="connsiteY71" fmla="*/ 2438400 h 2481179"/>
                    <a:gd name="connsiteX72" fmla="*/ 1016000 w 1187115"/>
                    <a:gd name="connsiteY72" fmla="*/ 2443747 h 2481179"/>
                    <a:gd name="connsiteX73" fmla="*/ 1069473 w 1187115"/>
                    <a:gd name="connsiteY73" fmla="*/ 2459790 h 2481179"/>
                    <a:gd name="connsiteX74" fmla="*/ 1117600 w 1187115"/>
                    <a:gd name="connsiteY74" fmla="*/ 2465137 h 2481179"/>
                    <a:gd name="connsiteX75" fmla="*/ 1155031 w 1187115"/>
                    <a:gd name="connsiteY75" fmla="*/ 2475832 h 2481179"/>
                    <a:gd name="connsiteX76" fmla="*/ 1187115 w 1187115"/>
                    <a:gd name="connsiteY76" fmla="*/ 2481179 h 248117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</a:cxnLst>
                  <a:rect l="l" t="t" r="r" b="b"/>
                  <a:pathLst>
                    <a:path w="1187115" h="2481179">
                      <a:moveTo>
                        <a:pt x="5347" y="0"/>
                      </a:moveTo>
                      <a:cubicBezTo>
                        <a:pt x="3565" y="8912"/>
                        <a:pt x="0" y="17648"/>
                        <a:pt x="0" y="26737"/>
                      </a:cubicBezTo>
                      <a:cubicBezTo>
                        <a:pt x="0" y="35826"/>
                        <a:pt x="2956" y="44705"/>
                        <a:pt x="5347" y="53474"/>
                      </a:cubicBezTo>
                      <a:cubicBezTo>
                        <a:pt x="8313" y="64350"/>
                        <a:pt x="12477" y="74863"/>
                        <a:pt x="16042" y="85558"/>
                      </a:cubicBezTo>
                      <a:cubicBezTo>
                        <a:pt x="18366" y="92530"/>
                        <a:pt x="19607" y="99817"/>
                        <a:pt x="21389" y="106947"/>
                      </a:cubicBezTo>
                      <a:cubicBezTo>
                        <a:pt x="23171" y="130119"/>
                        <a:pt x="25080" y="153282"/>
                        <a:pt x="26736" y="176463"/>
                      </a:cubicBezTo>
                      <a:cubicBezTo>
                        <a:pt x="28645" y="203191"/>
                        <a:pt x="28294" y="230147"/>
                        <a:pt x="32084" y="256674"/>
                      </a:cubicBezTo>
                      <a:cubicBezTo>
                        <a:pt x="33678" y="267834"/>
                        <a:pt x="40567" y="277704"/>
                        <a:pt x="42778" y="288758"/>
                      </a:cubicBezTo>
                      <a:lnTo>
                        <a:pt x="48126" y="315495"/>
                      </a:lnTo>
                      <a:cubicBezTo>
                        <a:pt x="55397" y="388209"/>
                        <a:pt x="54763" y="373924"/>
                        <a:pt x="58821" y="465221"/>
                      </a:cubicBezTo>
                      <a:cubicBezTo>
                        <a:pt x="66996" y="649152"/>
                        <a:pt x="58571" y="553626"/>
                        <a:pt x="69515" y="663074"/>
                      </a:cubicBezTo>
                      <a:cubicBezTo>
                        <a:pt x="70227" y="660937"/>
                        <a:pt x="79339" y="628917"/>
                        <a:pt x="85557" y="630990"/>
                      </a:cubicBezTo>
                      <a:cubicBezTo>
                        <a:pt x="92529" y="633314"/>
                        <a:pt x="88793" y="645340"/>
                        <a:pt x="90905" y="652379"/>
                      </a:cubicBezTo>
                      <a:cubicBezTo>
                        <a:pt x="107186" y="706645"/>
                        <a:pt x="97203" y="662476"/>
                        <a:pt x="106947" y="711200"/>
                      </a:cubicBezTo>
                      <a:cubicBezTo>
                        <a:pt x="110512" y="704070"/>
                        <a:pt x="117642" y="697782"/>
                        <a:pt x="117642" y="689811"/>
                      </a:cubicBezTo>
                      <a:cubicBezTo>
                        <a:pt x="117642" y="660114"/>
                        <a:pt x="90311" y="646635"/>
                        <a:pt x="122989" y="668421"/>
                      </a:cubicBezTo>
                      <a:cubicBezTo>
                        <a:pt x="141030" y="722548"/>
                        <a:pt x="122453" y="661987"/>
                        <a:pt x="133684" y="796758"/>
                      </a:cubicBezTo>
                      <a:cubicBezTo>
                        <a:pt x="134152" y="802375"/>
                        <a:pt x="137249" y="807453"/>
                        <a:pt x="139031" y="812800"/>
                      </a:cubicBezTo>
                      <a:cubicBezTo>
                        <a:pt x="127682" y="858199"/>
                        <a:pt x="131384" y="834102"/>
                        <a:pt x="139031" y="914400"/>
                      </a:cubicBezTo>
                      <a:cubicBezTo>
                        <a:pt x="141541" y="940754"/>
                        <a:pt x="142906" y="942068"/>
                        <a:pt x="149726" y="962526"/>
                      </a:cubicBezTo>
                      <a:cubicBezTo>
                        <a:pt x="150085" y="961988"/>
                        <a:pt x="166132" y="930805"/>
                        <a:pt x="176463" y="941137"/>
                      </a:cubicBezTo>
                      <a:cubicBezTo>
                        <a:pt x="184434" y="949108"/>
                        <a:pt x="183592" y="962526"/>
                        <a:pt x="187157" y="973221"/>
                      </a:cubicBezTo>
                      <a:lnTo>
                        <a:pt x="192505" y="989263"/>
                      </a:lnTo>
                      <a:cubicBezTo>
                        <a:pt x="194287" y="994610"/>
                        <a:pt x="194725" y="1000615"/>
                        <a:pt x="197852" y="1005305"/>
                      </a:cubicBezTo>
                      <a:lnTo>
                        <a:pt x="208547" y="1021347"/>
                      </a:lnTo>
                      <a:cubicBezTo>
                        <a:pt x="210329" y="1016000"/>
                        <a:pt x="213235" y="1010903"/>
                        <a:pt x="213894" y="1005305"/>
                      </a:cubicBezTo>
                      <a:cubicBezTo>
                        <a:pt x="216817" y="980458"/>
                        <a:pt x="211884" y="954354"/>
                        <a:pt x="219242" y="930442"/>
                      </a:cubicBezTo>
                      <a:cubicBezTo>
                        <a:pt x="220900" y="925055"/>
                        <a:pt x="229937" y="934007"/>
                        <a:pt x="235284" y="935790"/>
                      </a:cubicBezTo>
                      <a:cubicBezTo>
                        <a:pt x="244034" y="929957"/>
                        <a:pt x="260401" y="922016"/>
                        <a:pt x="262021" y="909053"/>
                      </a:cubicBezTo>
                      <a:cubicBezTo>
                        <a:pt x="263148" y="900034"/>
                        <a:pt x="258456" y="891228"/>
                        <a:pt x="256673" y="882316"/>
                      </a:cubicBezTo>
                      <a:cubicBezTo>
                        <a:pt x="258456" y="855579"/>
                        <a:pt x="257616" y="828537"/>
                        <a:pt x="262021" y="802105"/>
                      </a:cubicBezTo>
                      <a:cubicBezTo>
                        <a:pt x="263078" y="795766"/>
                        <a:pt x="269841" y="791811"/>
                        <a:pt x="272715" y="786063"/>
                      </a:cubicBezTo>
                      <a:cubicBezTo>
                        <a:pt x="275236" y="781021"/>
                        <a:pt x="276280" y="775368"/>
                        <a:pt x="278063" y="770021"/>
                      </a:cubicBezTo>
                      <a:lnTo>
                        <a:pt x="288757" y="802105"/>
                      </a:lnTo>
                      <a:lnTo>
                        <a:pt x="294105" y="818147"/>
                      </a:lnTo>
                      <a:cubicBezTo>
                        <a:pt x="295887" y="839537"/>
                        <a:pt x="297417" y="860949"/>
                        <a:pt x="299452" y="882316"/>
                      </a:cubicBezTo>
                      <a:cubicBezTo>
                        <a:pt x="302222" y="911403"/>
                        <a:pt x="306506" y="944093"/>
                        <a:pt x="310147" y="973221"/>
                      </a:cubicBezTo>
                      <a:cubicBezTo>
                        <a:pt x="311929" y="1014218"/>
                        <a:pt x="312347" y="1055296"/>
                        <a:pt x="315494" y="1096211"/>
                      </a:cubicBezTo>
                      <a:cubicBezTo>
                        <a:pt x="315926" y="1101831"/>
                        <a:pt x="320308" y="1106642"/>
                        <a:pt x="320842" y="1112253"/>
                      </a:cubicBezTo>
                      <a:cubicBezTo>
                        <a:pt x="323889" y="1144242"/>
                        <a:pt x="324052" y="1176443"/>
                        <a:pt x="326189" y="1208505"/>
                      </a:cubicBezTo>
                      <a:cubicBezTo>
                        <a:pt x="330550" y="1273931"/>
                        <a:pt x="325130" y="1253457"/>
                        <a:pt x="336884" y="1288716"/>
                      </a:cubicBezTo>
                      <a:cubicBezTo>
                        <a:pt x="338666" y="1320800"/>
                        <a:pt x="339322" y="1352966"/>
                        <a:pt x="342231" y="1384968"/>
                      </a:cubicBezTo>
                      <a:cubicBezTo>
                        <a:pt x="342896" y="1392287"/>
                        <a:pt x="347306" y="1399014"/>
                        <a:pt x="347578" y="1406358"/>
                      </a:cubicBezTo>
                      <a:cubicBezTo>
                        <a:pt x="350877" y="1495437"/>
                        <a:pt x="349565" y="1584649"/>
                        <a:pt x="352926" y="1673726"/>
                      </a:cubicBezTo>
                      <a:cubicBezTo>
                        <a:pt x="353139" y="1679359"/>
                        <a:pt x="356906" y="1684300"/>
                        <a:pt x="358273" y="1689768"/>
                      </a:cubicBezTo>
                      <a:cubicBezTo>
                        <a:pt x="360477" y="1698585"/>
                        <a:pt x="361838" y="1707593"/>
                        <a:pt x="363621" y="1716505"/>
                      </a:cubicBezTo>
                      <a:cubicBezTo>
                        <a:pt x="365403" y="1755719"/>
                        <a:pt x="364786" y="1795116"/>
                        <a:pt x="368968" y="1834147"/>
                      </a:cubicBezTo>
                      <a:cubicBezTo>
                        <a:pt x="370169" y="1845356"/>
                        <a:pt x="376098" y="1855537"/>
                        <a:pt x="379663" y="1866232"/>
                      </a:cubicBezTo>
                      <a:lnTo>
                        <a:pt x="385010" y="1882274"/>
                      </a:lnTo>
                      <a:cubicBezTo>
                        <a:pt x="395808" y="1990259"/>
                        <a:pt x="381968" y="1891506"/>
                        <a:pt x="401052" y="1967832"/>
                      </a:cubicBezTo>
                      <a:cubicBezTo>
                        <a:pt x="402835" y="1974962"/>
                        <a:pt x="404288" y="1982182"/>
                        <a:pt x="406400" y="1989221"/>
                      </a:cubicBezTo>
                      <a:cubicBezTo>
                        <a:pt x="409639" y="2000019"/>
                        <a:pt x="417094" y="2021305"/>
                        <a:pt x="417094" y="2021305"/>
                      </a:cubicBezTo>
                      <a:cubicBezTo>
                        <a:pt x="419520" y="2052834"/>
                        <a:pt x="419300" y="2086432"/>
                        <a:pt x="427789" y="2117558"/>
                      </a:cubicBezTo>
                      <a:cubicBezTo>
                        <a:pt x="430755" y="2128434"/>
                        <a:pt x="432231" y="2140262"/>
                        <a:pt x="438484" y="2149642"/>
                      </a:cubicBezTo>
                      <a:cubicBezTo>
                        <a:pt x="442049" y="2154989"/>
                        <a:pt x="446304" y="2159936"/>
                        <a:pt x="449178" y="2165684"/>
                      </a:cubicBezTo>
                      <a:cubicBezTo>
                        <a:pt x="451699" y="2170726"/>
                        <a:pt x="450540" y="2177740"/>
                        <a:pt x="454526" y="2181726"/>
                      </a:cubicBezTo>
                      <a:cubicBezTo>
                        <a:pt x="463615" y="2190815"/>
                        <a:pt x="486610" y="2203116"/>
                        <a:pt x="486610" y="2203116"/>
                      </a:cubicBezTo>
                      <a:cubicBezTo>
                        <a:pt x="524834" y="2260450"/>
                        <a:pt x="465304" y="2173429"/>
                        <a:pt x="513347" y="2235200"/>
                      </a:cubicBezTo>
                      <a:cubicBezTo>
                        <a:pt x="521238" y="2245346"/>
                        <a:pt x="527606" y="2256589"/>
                        <a:pt x="534736" y="2267284"/>
                      </a:cubicBezTo>
                      <a:cubicBezTo>
                        <a:pt x="538301" y="2272631"/>
                        <a:pt x="540084" y="2279761"/>
                        <a:pt x="545431" y="2283326"/>
                      </a:cubicBezTo>
                      <a:cubicBezTo>
                        <a:pt x="550778" y="2286891"/>
                        <a:pt x="556536" y="2289907"/>
                        <a:pt x="561473" y="2294021"/>
                      </a:cubicBezTo>
                      <a:cubicBezTo>
                        <a:pt x="575541" y="2305745"/>
                        <a:pt x="590026" y="2328657"/>
                        <a:pt x="609600" y="2331453"/>
                      </a:cubicBezTo>
                      <a:lnTo>
                        <a:pt x="647031" y="2336800"/>
                      </a:lnTo>
                      <a:cubicBezTo>
                        <a:pt x="691072" y="2351481"/>
                        <a:pt x="667955" y="2345901"/>
                        <a:pt x="716547" y="2352842"/>
                      </a:cubicBezTo>
                      <a:cubicBezTo>
                        <a:pt x="721894" y="2354625"/>
                        <a:pt x="726983" y="2357600"/>
                        <a:pt x="732589" y="2358190"/>
                      </a:cubicBezTo>
                      <a:cubicBezTo>
                        <a:pt x="761007" y="2361181"/>
                        <a:pt x="790283" y="2357204"/>
                        <a:pt x="818147" y="2363537"/>
                      </a:cubicBezTo>
                      <a:cubicBezTo>
                        <a:pt x="830681" y="2366385"/>
                        <a:pt x="837553" y="2382813"/>
                        <a:pt x="850231" y="2384926"/>
                      </a:cubicBezTo>
                      <a:lnTo>
                        <a:pt x="882315" y="2390274"/>
                      </a:lnTo>
                      <a:lnTo>
                        <a:pt x="914400" y="2411663"/>
                      </a:lnTo>
                      <a:cubicBezTo>
                        <a:pt x="919747" y="2415228"/>
                        <a:pt x="924140" y="2421098"/>
                        <a:pt x="930442" y="2422358"/>
                      </a:cubicBezTo>
                      <a:cubicBezTo>
                        <a:pt x="939354" y="2424140"/>
                        <a:pt x="948410" y="2425314"/>
                        <a:pt x="957178" y="2427705"/>
                      </a:cubicBezTo>
                      <a:cubicBezTo>
                        <a:pt x="968054" y="2430671"/>
                        <a:pt x="978208" y="2436189"/>
                        <a:pt x="989263" y="2438400"/>
                      </a:cubicBezTo>
                      <a:cubicBezTo>
                        <a:pt x="998175" y="2440182"/>
                        <a:pt x="1007231" y="2441356"/>
                        <a:pt x="1016000" y="2443747"/>
                      </a:cubicBezTo>
                      <a:cubicBezTo>
                        <a:pt x="1034851" y="2448888"/>
                        <a:pt x="1050320" y="2456843"/>
                        <a:pt x="1069473" y="2459790"/>
                      </a:cubicBezTo>
                      <a:cubicBezTo>
                        <a:pt x="1085426" y="2462244"/>
                        <a:pt x="1101558" y="2463355"/>
                        <a:pt x="1117600" y="2465137"/>
                      </a:cubicBezTo>
                      <a:cubicBezTo>
                        <a:pt x="1132884" y="2470231"/>
                        <a:pt x="1138253" y="2472476"/>
                        <a:pt x="1155031" y="2475832"/>
                      </a:cubicBezTo>
                      <a:cubicBezTo>
                        <a:pt x="1165663" y="2477958"/>
                        <a:pt x="1187115" y="2481179"/>
                        <a:pt x="1187115" y="2481179"/>
                      </a:cubicBezTo>
                    </a:path>
                  </a:pathLst>
                </a:custGeom>
                <a:noFill/>
                <a:ln w="635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/>
                    <a:cs typeface="Arial"/>
                  </a:endParaRPr>
                </a:p>
              </p:txBody>
            </p:sp>
            <p:sp>
              <p:nvSpPr>
                <p:cNvPr id="153" name="正方形/長方形 152"/>
                <p:cNvSpPr/>
                <p:nvPr/>
              </p:nvSpPr>
              <p:spPr>
                <a:xfrm>
                  <a:off x="1484416" y="2238499"/>
                  <a:ext cx="2642259" cy="2643662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/>
                    <a:cs typeface="Arial"/>
                  </a:endParaRPr>
                </a:p>
              </p:txBody>
            </p:sp>
            <p:cxnSp>
              <p:nvCxnSpPr>
                <p:cNvPr id="154" name="直線コネクタ 153"/>
                <p:cNvCxnSpPr/>
                <p:nvPr/>
              </p:nvCxnSpPr>
              <p:spPr>
                <a:xfrm>
                  <a:off x="2775855" y="4602679"/>
                  <a:ext cx="0" cy="124691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直線コネクタ 154"/>
                <p:cNvCxnSpPr/>
                <p:nvPr/>
              </p:nvCxnSpPr>
              <p:spPr>
                <a:xfrm>
                  <a:off x="3814251" y="4602679"/>
                  <a:ext cx="0" cy="124691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直線コネクタ 155"/>
                <p:cNvCxnSpPr/>
                <p:nvPr/>
              </p:nvCxnSpPr>
              <p:spPr>
                <a:xfrm>
                  <a:off x="2775855" y="4665024"/>
                  <a:ext cx="1038396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8" name="Rectangle 97"/>
              <p:cNvSpPr>
                <a:spLocks noChangeArrowheads="1"/>
              </p:cNvSpPr>
              <p:nvPr/>
            </p:nvSpPr>
            <p:spPr bwMode="auto">
              <a:xfrm>
                <a:off x="3631062" y="1640835"/>
                <a:ext cx="234950" cy="123111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prstTxWarp prst="textNoShape">
                  <a:avLst/>
                </a:prstTxWarp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42.6</a:t>
                </a:r>
                <a:endParaRPr lang="en-US" altLang="ja-JP" sz="800" dirty="0">
                  <a:latin typeface="Arial"/>
                  <a:ea typeface="Arial" charset="0"/>
                  <a:cs typeface="Arial"/>
                </a:endParaRPr>
              </a:p>
            </p:txBody>
          </p:sp>
          <p:grpSp>
            <p:nvGrpSpPr>
              <p:cNvPr id="237" name="グループ化 117"/>
              <p:cNvGrpSpPr>
                <a:grpSpLocks noChangeAspect="1"/>
              </p:cNvGrpSpPr>
              <p:nvPr/>
            </p:nvGrpSpPr>
            <p:grpSpPr>
              <a:xfrm>
                <a:off x="2647513" y="638577"/>
                <a:ext cx="260066" cy="1328175"/>
                <a:chOff x="4868216" y="2140387"/>
                <a:chExt cx="377261" cy="2656348"/>
              </a:xfrm>
            </p:grpSpPr>
            <p:sp>
              <p:nvSpPr>
                <p:cNvPr id="238" name="テキスト ボックス 237"/>
                <p:cNvSpPr txBox="1"/>
                <p:nvPr/>
              </p:nvSpPr>
              <p:spPr>
                <a:xfrm>
                  <a:off x="4925919" y="2803501"/>
                  <a:ext cx="271003" cy="246222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8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/>
                      <a:cs typeface="Arial"/>
                    </a:rPr>
                    <a:t>90</a:t>
                  </a:r>
                  <a:endParaRPr kumimoji="1" lang="ja-JP" altLang="en-US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/>
                    <a:cs typeface="Arial"/>
                  </a:endParaRPr>
                </a:p>
              </p:txBody>
            </p:sp>
            <p:sp>
              <p:nvSpPr>
                <p:cNvPr id="239" name="テキスト ボックス 238"/>
                <p:cNvSpPr txBox="1"/>
                <p:nvPr/>
              </p:nvSpPr>
              <p:spPr>
                <a:xfrm>
                  <a:off x="4925912" y="3381628"/>
                  <a:ext cx="271003" cy="246222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8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/>
                      <a:cs typeface="Arial"/>
                    </a:rPr>
                    <a:t>60</a:t>
                  </a:r>
                  <a:endParaRPr kumimoji="1" lang="ja-JP" altLang="en-US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/>
                    <a:cs typeface="Arial"/>
                  </a:endParaRPr>
                </a:p>
              </p:txBody>
            </p:sp>
            <p:sp>
              <p:nvSpPr>
                <p:cNvPr id="240" name="テキスト ボックス 239"/>
                <p:cNvSpPr txBox="1"/>
                <p:nvPr/>
              </p:nvSpPr>
              <p:spPr>
                <a:xfrm>
                  <a:off x="4925915" y="3959754"/>
                  <a:ext cx="271003" cy="246222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ja-JP" sz="8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/>
                      <a:cs typeface="Arial"/>
                    </a:rPr>
                    <a:t>30</a:t>
                  </a:r>
                  <a:endParaRPr kumimoji="1" lang="ja-JP" altLang="en-US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/>
                    <a:cs typeface="Arial"/>
                  </a:endParaRPr>
                </a:p>
              </p:txBody>
            </p:sp>
            <p:sp>
              <p:nvSpPr>
                <p:cNvPr id="241" name="テキスト ボックス 240"/>
                <p:cNvSpPr txBox="1"/>
                <p:nvPr/>
              </p:nvSpPr>
              <p:spPr>
                <a:xfrm>
                  <a:off x="4983621" y="4550513"/>
                  <a:ext cx="188234" cy="246222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8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/>
                      <a:cs typeface="Arial"/>
                    </a:rPr>
                    <a:t>0</a:t>
                  </a:r>
                  <a:endParaRPr kumimoji="1" lang="ja-JP" altLang="en-US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/>
                    <a:cs typeface="Arial"/>
                  </a:endParaRPr>
                </a:p>
              </p:txBody>
            </p:sp>
            <p:grpSp>
              <p:nvGrpSpPr>
                <p:cNvPr id="242" name="グループ化 31"/>
                <p:cNvGrpSpPr/>
                <p:nvPr/>
              </p:nvGrpSpPr>
              <p:grpSpPr>
                <a:xfrm>
                  <a:off x="5168288" y="2140387"/>
                  <a:ext cx="77189" cy="2505215"/>
                  <a:chOff x="5168288" y="2140387"/>
                  <a:chExt cx="77189" cy="2505215"/>
                </a:xfrm>
              </p:grpSpPr>
              <p:cxnSp>
                <p:nvCxnSpPr>
                  <p:cNvPr id="244" name="直線コネクタ 243"/>
                  <p:cNvCxnSpPr/>
                  <p:nvPr/>
                </p:nvCxnSpPr>
                <p:spPr>
                  <a:xfrm>
                    <a:off x="5168288" y="2333096"/>
                    <a:ext cx="77189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45" name="直線コネクタ 244"/>
                  <p:cNvCxnSpPr/>
                  <p:nvPr/>
                </p:nvCxnSpPr>
                <p:spPr>
                  <a:xfrm>
                    <a:off x="5191477" y="2525805"/>
                    <a:ext cx="540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46" name="直線コネクタ 245"/>
                  <p:cNvCxnSpPr/>
                  <p:nvPr/>
                </p:nvCxnSpPr>
                <p:spPr>
                  <a:xfrm>
                    <a:off x="5191477" y="2718514"/>
                    <a:ext cx="540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47" name="直線コネクタ 246"/>
                  <p:cNvCxnSpPr/>
                  <p:nvPr/>
                </p:nvCxnSpPr>
                <p:spPr>
                  <a:xfrm>
                    <a:off x="5191477" y="3103932"/>
                    <a:ext cx="540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48" name="直線コネクタ 247"/>
                  <p:cNvCxnSpPr/>
                  <p:nvPr/>
                </p:nvCxnSpPr>
                <p:spPr>
                  <a:xfrm>
                    <a:off x="5191477" y="3296641"/>
                    <a:ext cx="540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49" name="直線コネクタ 248"/>
                  <p:cNvCxnSpPr/>
                  <p:nvPr/>
                </p:nvCxnSpPr>
                <p:spPr>
                  <a:xfrm>
                    <a:off x="5169877" y="3489350"/>
                    <a:ext cx="756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50" name="直線コネクタ 249"/>
                  <p:cNvCxnSpPr/>
                  <p:nvPr/>
                </p:nvCxnSpPr>
                <p:spPr>
                  <a:xfrm>
                    <a:off x="5191477" y="3682059"/>
                    <a:ext cx="540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51" name="直線コネクタ 250"/>
                  <p:cNvCxnSpPr/>
                  <p:nvPr/>
                </p:nvCxnSpPr>
                <p:spPr>
                  <a:xfrm>
                    <a:off x="5191477" y="4452895"/>
                    <a:ext cx="540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52" name="直線コネクタ 251"/>
                  <p:cNvCxnSpPr/>
                  <p:nvPr/>
                </p:nvCxnSpPr>
                <p:spPr>
                  <a:xfrm>
                    <a:off x="5191477" y="3874768"/>
                    <a:ext cx="540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53" name="直線コネクタ 252"/>
                  <p:cNvCxnSpPr/>
                  <p:nvPr/>
                </p:nvCxnSpPr>
                <p:spPr>
                  <a:xfrm>
                    <a:off x="5191477" y="4260186"/>
                    <a:ext cx="540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54" name="直線コネクタ 253"/>
                  <p:cNvCxnSpPr/>
                  <p:nvPr/>
                </p:nvCxnSpPr>
                <p:spPr>
                  <a:xfrm>
                    <a:off x="5168288" y="2911223"/>
                    <a:ext cx="77189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55" name="直線コネクタ 254"/>
                  <p:cNvCxnSpPr/>
                  <p:nvPr/>
                </p:nvCxnSpPr>
                <p:spPr>
                  <a:xfrm>
                    <a:off x="5168288" y="4067477"/>
                    <a:ext cx="77189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56" name="直線コネクタ 255"/>
                  <p:cNvCxnSpPr/>
                  <p:nvPr/>
                </p:nvCxnSpPr>
                <p:spPr>
                  <a:xfrm>
                    <a:off x="5168288" y="4645602"/>
                    <a:ext cx="77189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57" name="直線コネクタ 256"/>
                  <p:cNvCxnSpPr/>
                  <p:nvPr/>
                </p:nvCxnSpPr>
                <p:spPr>
                  <a:xfrm>
                    <a:off x="5191477" y="2140387"/>
                    <a:ext cx="54000" cy="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</p:grpSp>
            <p:sp>
              <p:nvSpPr>
                <p:cNvPr id="243" name="テキスト ボックス 242"/>
                <p:cNvSpPr txBox="1"/>
                <p:nvPr/>
              </p:nvSpPr>
              <p:spPr>
                <a:xfrm>
                  <a:off x="4868216" y="2225377"/>
                  <a:ext cx="353772" cy="246222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8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/>
                      <a:cs typeface="Arial"/>
                    </a:rPr>
                    <a:t>120</a:t>
                  </a:r>
                  <a:endParaRPr kumimoji="1" lang="ja-JP" altLang="en-US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258" name="グループ化 196"/>
              <p:cNvGrpSpPr/>
              <p:nvPr/>
            </p:nvGrpSpPr>
            <p:grpSpPr>
              <a:xfrm>
                <a:off x="2911437" y="1879024"/>
                <a:ext cx="1331480" cy="215444"/>
                <a:chOff x="2811900" y="1856226"/>
                <a:chExt cx="1331480" cy="215444"/>
              </a:xfrm>
            </p:grpSpPr>
            <p:grpSp>
              <p:nvGrpSpPr>
                <p:cNvPr id="259" name="グループ化 138"/>
                <p:cNvGrpSpPr>
                  <a:grpSpLocks noChangeAspect="1"/>
                </p:cNvGrpSpPr>
                <p:nvPr/>
              </p:nvGrpSpPr>
              <p:grpSpPr>
                <a:xfrm>
                  <a:off x="2811900" y="1865954"/>
                  <a:ext cx="1315051" cy="37661"/>
                  <a:chOff x="5852160" y="3933775"/>
                  <a:chExt cx="2630103" cy="75322"/>
                </a:xfrm>
              </p:grpSpPr>
              <p:grpSp>
                <p:nvGrpSpPr>
                  <p:cNvPr id="265" name="グループ化 83"/>
                  <p:cNvGrpSpPr/>
                  <p:nvPr/>
                </p:nvGrpSpPr>
                <p:grpSpPr>
                  <a:xfrm>
                    <a:off x="5852160" y="3937786"/>
                    <a:ext cx="2569244" cy="71311"/>
                    <a:chOff x="5852160" y="3937786"/>
                    <a:chExt cx="2569244" cy="71311"/>
                  </a:xfrm>
                </p:grpSpPr>
                <p:cxnSp>
                  <p:nvCxnSpPr>
                    <p:cNvPr id="267" name="直線コネクタ 266"/>
                    <p:cNvCxnSpPr/>
                    <p:nvPr/>
                  </p:nvCxnSpPr>
                  <p:spPr>
                    <a:xfrm rot="16200000" flipH="1">
                      <a:off x="5816505" y="3973442"/>
                      <a:ext cx="7131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8" name="直線コネクタ 267"/>
                    <p:cNvCxnSpPr/>
                    <p:nvPr/>
                  </p:nvCxnSpPr>
                  <p:spPr>
                    <a:xfrm rot="16200000" flipH="1">
                      <a:off x="5960792" y="3959387"/>
                      <a:ext cx="432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9" name="直線コネクタ 268"/>
                    <p:cNvCxnSpPr/>
                    <p:nvPr/>
                  </p:nvCxnSpPr>
                  <p:spPr>
                    <a:xfrm rot="16200000" flipH="1">
                      <a:off x="587654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0" name="直線コネクタ 269"/>
                    <p:cNvCxnSpPr/>
                    <p:nvPr/>
                  </p:nvCxnSpPr>
                  <p:spPr>
                    <a:xfrm rot="16200000" flipH="1">
                      <a:off x="5857142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1" name="直線コネクタ 270"/>
                    <p:cNvCxnSpPr/>
                    <p:nvPr/>
                  </p:nvCxnSpPr>
                  <p:spPr>
                    <a:xfrm rot="16200000" flipH="1">
                      <a:off x="5912562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2" name="直線コネクタ 271"/>
                    <p:cNvCxnSpPr/>
                    <p:nvPr/>
                  </p:nvCxnSpPr>
                  <p:spPr>
                    <a:xfrm rot="16200000" flipH="1">
                      <a:off x="5940272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3" name="直線コネクタ 272"/>
                    <p:cNvCxnSpPr/>
                    <p:nvPr/>
                  </p:nvCxnSpPr>
                  <p:spPr>
                    <a:xfrm rot="16200000" flipH="1">
                      <a:off x="600123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4" name="直線コネクタ 273"/>
                    <p:cNvCxnSpPr/>
                    <p:nvPr/>
                  </p:nvCxnSpPr>
                  <p:spPr>
                    <a:xfrm rot="16200000" flipH="1">
                      <a:off x="602894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5" name="直線コネクタ 274"/>
                    <p:cNvCxnSpPr/>
                    <p:nvPr/>
                  </p:nvCxnSpPr>
                  <p:spPr>
                    <a:xfrm rot="16200000" flipH="1">
                      <a:off x="605665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6" name="直線コネクタ 275"/>
                    <p:cNvCxnSpPr/>
                    <p:nvPr/>
                  </p:nvCxnSpPr>
                  <p:spPr>
                    <a:xfrm rot="16200000" flipH="1">
                      <a:off x="6095448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7" name="直線コネクタ 276"/>
                    <p:cNvCxnSpPr/>
                    <p:nvPr/>
                  </p:nvCxnSpPr>
                  <p:spPr>
                    <a:xfrm rot="16200000" flipH="1">
                      <a:off x="608436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8" name="直線コネクタ 277"/>
                    <p:cNvCxnSpPr/>
                    <p:nvPr/>
                  </p:nvCxnSpPr>
                  <p:spPr>
                    <a:xfrm rot="16200000" flipH="1">
                      <a:off x="6100990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9" name="直線コネクタ 278"/>
                    <p:cNvCxnSpPr/>
                    <p:nvPr/>
                  </p:nvCxnSpPr>
                  <p:spPr>
                    <a:xfrm rot="16200000" flipH="1">
                      <a:off x="6203808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0" name="直線コネクタ 279"/>
                    <p:cNvCxnSpPr/>
                    <p:nvPr/>
                  </p:nvCxnSpPr>
                  <p:spPr>
                    <a:xfrm rot="16200000" flipH="1">
                      <a:off x="6233998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1" name="直線コネクタ 280"/>
                    <p:cNvCxnSpPr/>
                    <p:nvPr/>
                  </p:nvCxnSpPr>
                  <p:spPr>
                    <a:xfrm rot="16200000" flipH="1">
                      <a:off x="6311586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2" name="直線コネクタ 281"/>
                    <p:cNvCxnSpPr/>
                    <p:nvPr/>
                  </p:nvCxnSpPr>
                  <p:spPr>
                    <a:xfrm rot="16200000" flipH="1">
                      <a:off x="6285407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3" name="直線コネクタ 282"/>
                    <p:cNvCxnSpPr/>
                    <p:nvPr/>
                  </p:nvCxnSpPr>
                  <p:spPr>
                    <a:xfrm rot="16200000" flipH="1">
                      <a:off x="6357157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4" name="直線コネクタ 283"/>
                    <p:cNvCxnSpPr/>
                    <p:nvPr/>
                  </p:nvCxnSpPr>
                  <p:spPr>
                    <a:xfrm rot="16200000" flipH="1">
                      <a:off x="6336520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5" name="直線コネクタ 284"/>
                    <p:cNvCxnSpPr/>
                    <p:nvPr/>
                  </p:nvCxnSpPr>
                  <p:spPr>
                    <a:xfrm rot="16200000" flipH="1">
                      <a:off x="6563742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6" name="直線コネクタ 285"/>
                    <p:cNvCxnSpPr/>
                    <p:nvPr/>
                  </p:nvCxnSpPr>
                  <p:spPr>
                    <a:xfrm rot="16200000" flipH="1">
                      <a:off x="668012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7" name="直線コネクタ 286"/>
                    <p:cNvCxnSpPr/>
                    <p:nvPr/>
                  </p:nvCxnSpPr>
                  <p:spPr>
                    <a:xfrm rot="16200000" flipH="1">
                      <a:off x="676325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8" name="直線コネクタ 287"/>
                    <p:cNvCxnSpPr/>
                    <p:nvPr/>
                  </p:nvCxnSpPr>
                  <p:spPr>
                    <a:xfrm rot="16200000" flipH="1">
                      <a:off x="6919665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9" name="直線コネクタ 288"/>
                    <p:cNvCxnSpPr/>
                    <p:nvPr/>
                  </p:nvCxnSpPr>
                  <p:spPr>
                    <a:xfrm rot="16200000" flipH="1">
                      <a:off x="688794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0" name="直線コネクタ 289"/>
                    <p:cNvCxnSpPr/>
                    <p:nvPr/>
                  </p:nvCxnSpPr>
                  <p:spPr>
                    <a:xfrm rot="16200000" flipH="1">
                      <a:off x="6965532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1" name="直線コネクタ 290"/>
                    <p:cNvCxnSpPr/>
                    <p:nvPr/>
                  </p:nvCxnSpPr>
                  <p:spPr>
                    <a:xfrm rot="16200000" flipH="1">
                      <a:off x="699878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2" name="直線コネクタ 291"/>
                    <p:cNvCxnSpPr/>
                    <p:nvPr/>
                  </p:nvCxnSpPr>
                  <p:spPr>
                    <a:xfrm rot="16200000" flipH="1">
                      <a:off x="7212146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3" name="直線コネクタ 292"/>
                    <p:cNvCxnSpPr/>
                    <p:nvPr/>
                  </p:nvCxnSpPr>
                  <p:spPr>
                    <a:xfrm rot="16200000" flipH="1">
                      <a:off x="7322986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4" name="直線コネクタ 293"/>
                    <p:cNvCxnSpPr/>
                    <p:nvPr/>
                  </p:nvCxnSpPr>
                  <p:spPr>
                    <a:xfrm rot="16200000" flipH="1">
                      <a:off x="7399329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5" name="直線コネクタ 294"/>
                    <p:cNvCxnSpPr/>
                    <p:nvPr/>
                  </p:nvCxnSpPr>
                  <p:spPr>
                    <a:xfrm rot="16200000" flipH="1">
                      <a:off x="7503096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6" name="直線コネクタ 295"/>
                    <p:cNvCxnSpPr/>
                    <p:nvPr/>
                  </p:nvCxnSpPr>
                  <p:spPr>
                    <a:xfrm rot="16200000" flipH="1">
                      <a:off x="7600076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7" name="直線コネクタ 296"/>
                    <p:cNvCxnSpPr/>
                    <p:nvPr/>
                  </p:nvCxnSpPr>
                  <p:spPr>
                    <a:xfrm rot="16200000" flipH="1">
                      <a:off x="7583450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8" name="直線コネクタ 297"/>
                    <p:cNvCxnSpPr/>
                    <p:nvPr/>
                  </p:nvCxnSpPr>
                  <p:spPr>
                    <a:xfrm rot="16200000" flipH="1">
                      <a:off x="753911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9" name="直線コネクタ 298"/>
                    <p:cNvCxnSpPr/>
                    <p:nvPr/>
                  </p:nvCxnSpPr>
                  <p:spPr>
                    <a:xfrm rot="16200000" flipH="1">
                      <a:off x="7813438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0" name="直線コネクタ 299"/>
                    <p:cNvCxnSpPr/>
                    <p:nvPr/>
                  </p:nvCxnSpPr>
                  <p:spPr>
                    <a:xfrm rot="16200000" flipH="1">
                      <a:off x="7920267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1" name="直線コネクタ 300"/>
                    <p:cNvCxnSpPr/>
                    <p:nvPr/>
                  </p:nvCxnSpPr>
                  <p:spPr>
                    <a:xfrm rot="16200000" flipH="1">
                      <a:off x="7985526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2" name="直線コネクタ 301"/>
                    <p:cNvCxnSpPr/>
                    <p:nvPr/>
                  </p:nvCxnSpPr>
                  <p:spPr>
                    <a:xfrm rot="16200000" flipH="1">
                      <a:off x="8093304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3" name="直線コネクタ 302"/>
                    <p:cNvCxnSpPr/>
                    <p:nvPr/>
                  </p:nvCxnSpPr>
                  <p:spPr>
                    <a:xfrm rot="16200000" flipH="1">
                      <a:off x="8136395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4" name="直線コネクタ 303"/>
                    <p:cNvCxnSpPr/>
                    <p:nvPr/>
                  </p:nvCxnSpPr>
                  <p:spPr>
                    <a:xfrm rot="16200000" flipH="1">
                      <a:off x="8173658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5" name="直線コネクタ 304"/>
                    <p:cNvCxnSpPr/>
                    <p:nvPr/>
                  </p:nvCxnSpPr>
                  <p:spPr>
                    <a:xfrm rot="16200000" flipH="1">
                      <a:off x="8198888" y="3952187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6" name="直線コネクタ 305"/>
                    <p:cNvCxnSpPr/>
                    <p:nvPr/>
                  </p:nvCxnSpPr>
                  <p:spPr>
                    <a:xfrm rot="16200000" flipH="1">
                      <a:off x="8407004" y="3952186"/>
                      <a:ext cx="288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7" name="直線コネクタ 306"/>
                    <p:cNvCxnSpPr/>
                    <p:nvPr/>
                  </p:nvCxnSpPr>
                  <p:spPr>
                    <a:xfrm rot="16200000" flipH="1">
                      <a:off x="6057147" y="3973442"/>
                      <a:ext cx="7131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8" name="直線コネクタ 307"/>
                    <p:cNvCxnSpPr/>
                    <p:nvPr/>
                  </p:nvCxnSpPr>
                  <p:spPr>
                    <a:xfrm rot="16200000" flipH="1">
                      <a:off x="6089217" y="3973442"/>
                      <a:ext cx="7131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9" name="直線コネクタ 308"/>
                    <p:cNvCxnSpPr/>
                    <p:nvPr/>
                  </p:nvCxnSpPr>
                  <p:spPr>
                    <a:xfrm rot="16200000" flipH="1">
                      <a:off x="6365976" y="3973442"/>
                      <a:ext cx="7131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0" name="直線コネクタ 309"/>
                    <p:cNvCxnSpPr/>
                    <p:nvPr/>
                  </p:nvCxnSpPr>
                  <p:spPr>
                    <a:xfrm rot="16200000" flipH="1">
                      <a:off x="7007718" y="3973442"/>
                      <a:ext cx="7131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1" name="直線コネクタ 310"/>
                    <p:cNvCxnSpPr/>
                    <p:nvPr/>
                  </p:nvCxnSpPr>
                  <p:spPr>
                    <a:xfrm rot="16200000" flipH="1">
                      <a:off x="7608404" y="3973442"/>
                      <a:ext cx="7131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2" name="直線コネクタ 311"/>
                    <p:cNvCxnSpPr/>
                    <p:nvPr/>
                  </p:nvCxnSpPr>
                  <p:spPr>
                    <a:xfrm rot="16200000" flipH="1">
                      <a:off x="8201699" y="3973442"/>
                      <a:ext cx="7131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3" name="直線コネクタ 312"/>
                    <p:cNvCxnSpPr/>
                    <p:nvPr/>
                  </p:nvCxnSpPr>
                  <p:spPr>
                    <a:xfrm rot="16200000" flipH="1">
                      <a:off x="6253577" y="3959387"/>
                      <a:ext cx="432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4" name="直線コネクタ 313"/>
                    <p:cNvCxnSpPr/>
                    <p:nvPr/>
                  </p:nvCxnSpPr>
                  <p:spPr>
                    <a:xfrm rot="16200000" flipH="1">
                      <a:off x="6827150" y="3959387"/>
                      <a:ext cx="432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5" name="直線コネクタ 314"/>
                    <p:cNvCxnSpPr/>
                    <p:nvPr/>
                  </p:nvCxnSpPr>
                  <p:spPr>
                    <a:xfrm rot="16200000" flipH="1">
                      <a:off x="7446000" y="3959387"/>
                      <a:ext cx="432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6" name="直線コネクタ 315"/>
                    <p:cNvCxnSpPr/>
                    <p:nvPr/>
                  </p:nvCxnSpPr>
                  <p:spPr>
                    <a:xfrm rot="16200000" flipH="1">
                      <a:off x="8043621" y="3959387"/>
                      <a:ext cx="432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66" name="直線コネクタ 265"/>
                  <p:cNvCxnSpPr/>
                  <p:nvPr/>
                </p:nvCxnSpPr>
                <p:spPr>
                  <a:xfrm>
                    <a:off x="5852160" y="3933775"/>
                    <a:ext cx="2630103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60" name="テキスト ボックス 259"/>
                <p:cNvSpPr txBox="1"/>
                <p:nvPr/>
              </p:nvSpPr>
              <p:spPr>
                <a:xfrm>
                  <a:off x="2824970" y="1856226"/>
                  <a:ext cx="21431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 smtClean="0">
                      <a:latin typeface="Arial"/>
                      <a:cs typeface="Arial"/>
                    </a:rPr>
                    <a:t>0</a:t>
                  </a:r>
                  <a:endParaRPr kumimoji="1" lang="ja-JP" alt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61" name="テキスト ボックス 260"/>
                <p:cNvSpPr txBox="1"/>
                <p:nvPr/>
              </p:nvSpPr>
              <p:spPr>
                <a:xfrm>
                  <a:off x="3019624" y="1856226"/>
                  <a:ext cx="204790" cy="215444"/>
                </a:xfrm>
                <a:prstGeom prst="rect">
                  <a:avLst/>
                </a:prstGeom>
                <a:noFill/>
              </p:spPr>
              <p:txBody>
                <a:bodyPr wrap="square" lIns="0" rIns="0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cs typeface="Arial"/>
                    </a:rPr>
                    <a:t>1</a:t>
                  </a:r>
                  <a:r>
                    <a:rPr kumimoji="1" lang="en-US" altLang="ja-JP" sz="800" dirty="0" smtClean="0">
                      <a:latin typeface="Arial"/>
                      <a:cs typeface="Arial"/>
                    </a:rPr>
                    <a:t>0</a:t>
                  </a:r>
                  <a:r>
                    <a:rPr kumimoji="1" lang="en-US" altLang="ja-JP" sz="800" baseline="30000" dirty="0" smtClean="0">
                      <a:latin typeface="Arial"/>
                      <a:cs typeface="Arial"/>
                    </a:rPr>
                    <a:t>2</a:t>
                  </a:r>
                  <a:endParaRPr kumimoji="1" lang="ja-JP" altLang="en-US" sz="800" baseline="30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62" name="テキスト ボックス 261"/>
                <p:cNvSpPr txBox="1"/>
                <p:nvPr/>
              </p:nvSpPr>
              <p:spPr>
                <a:xfrm>
                  <a:off x="3334560" y="1856226"/>
                  <a:ext cx="204790" cy="215444"/>
                </a:xfrm>
                <a:prstGeom prst="rect">
                  <a:avLst/>
                </a:prstGeom>
                <a:noFill/>
              </p:spPr>
              <p:txBody>
                <a:bodyPr wrap="square" lIns="0" rIns="0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cs typeface="Arial"/>
                    </a:rPr>
                    <a:t>1</a:t>
                  </a:r>
                  <a:r>
                    <a:rPr kumimoji="1" lang="en-US" altLang="ja-JP" sz="800" dirty="0" smtClean="0">
                      <a:latin typeface="Arial"/>
                      <a:cs typeface="Arial"/>
                    </a:rPr>
                    <a:t>0</a:t>
                  </a:r>
                  <a:r>
                    <a:rPr lang="en-US" altLang="ja-JP" sz="800" baseline="30000" dirty="0" smtClean="0">
                      <a:latin typeface="Arial"/>
                      <a:cs typeface="Arial"/>
                    </a:rPr>
                    <a:t>3</a:t>
                  </a:r>
                  <a:endParaRPr kumimoji="1" lang="ja-JP" altLang="en-US" sz="800" baseline="30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63" name="テキスト ボックス 262"/>
                <p:cNvSpPr txBox="1"/>
                <p:nvPr/>
              </p:nvSpPr>
              <p:spPr>
                <a:xfrm>
                  <a:off x="3639768" y="1856226"/>
                  <a:ext cx="204790" cy="215444"/>
                </a:xfrm>
                <a:prstGeom prst="rect">
                  <a:avLst/>
                </a:prstGeom>
                <a:noFill/>
              </p:spPr>
              <p:txBody>
                <a:bodyPr wrap="square" lIns="0" rIns="0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cs typeface="Arial"/>
                    </a:rPr>
                    <a:t>1</a:t>
                  </a:r>
                  <a:r>
                    <a:rPr kumimoji="1" lang="en-US" altLang="ja-JP" sz="800" dirty="0" smtClean="0">
                      <a:latin typeface="Arial"/>
                      <a:cs typeface="Arial"/>
                    </a:rPr>
                    <a:t>0</a:t>
                  </a:r>
                  <a:r>
                    <a:rPr lang="en-US" altLang="ja-JP" sz="800" baseline="30000" dirty="0" smtClean="0">
                      <a:latin typeface="Arial"/>
                      <a:cs typeface="Arial"/>
                    </a:rPr>
                    <a:t>4</a:t>
                  </a:r>
                  <a:endParaRPr kumimoji="1" lang="ja-JP" altLang="en-US" sz="800" baseline="30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64" name="テキスト ボックス 263"/>
                <p:cNvSpPr txBox="1"/>
                <p:nvPr/>
              </p:nvSpPr>
              <p:spPr>
                <a:xfrm>
                  <a:off x="3938590" y="1856226"/>
                  <a:ext cx="204790" cy="215444"/>
                </a:xfrm>
                <a:prstGeom prst="rect">
                  <a:avLst/>
                </a:prstGeom>
                <a:noFill/>
              </p:spPr>
              <p:txBody>
                <a:bodyPr wrap="square" lIns="0" rIns="0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cs typeface="Arial"/>
                    </a:rPr>
                    <a:t>1</a:t>
                  </a:r>
                  <a:r>
                    <a:rPr kumimoji="1" lang="en-US" altLang="ja-JP" sz="800" dirty="0" smtClean="0">
                      <a:latin typeface="Arial"/>
                      <a:cs typeface="Arial"/>
                    </a:rPr>
                    <a:t>0</a:t>
                  </a:r>
                  <a:r>
                    <a:rPr lang="en-US" altLang="ja-JP" sz="800" baseline="30000" dirty="0" smtClean="0">
                      <a:latin typeface="Arial"/>
                      <a:cs typeface="Arial"/>
                    </a:rPr>
                    <a:t>5</a:t>
                  </a:r>
                  <a:endParaRPr kumimoji="1" lang="ja-JP" altLang="en-US" sz="800" baseline="30000" dirty="0">
                    <a:latin typeface="Arial"/>
                    <a:cs typeface="Arial"/>
                  </a:endParaRPr>
                </a:p>
              </p:txBody>
            </p:sp>
          </p:grpSp>
        </p:grpSp>
        <p:sp>
          <p:nvSpPr>
            <p:cNvPr id="317" name="Rectangle 18"/>
            <p:cNvSpPr>
              <a:spLocks noChangeArrowheads="1"/>
            </p:cNvSpPr>
            <p:nvPr/>
          </p:nvSpPr>
          <p:spPr bwMode="auto">
            <a:xfrm>
              <a:off x="1556792" y="2267744"/>
              <a:ext cx="320776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900" dirty="0" smtClean="0">
                  <a:solidFill>
                    <a:srgbClr val="000000"/>
                  </a:solidFill>
                  <a:latin typeface="Arial"/>
                  <a:ea typeface="Arial" charset="0"/>
                  <a:cs typeface="Arial"/>
                </a:rPr>
                <a:t>Foxp3</a:t>
              </a:r>
              <a:endParaRPr lang="en-US" altLang="ja-JP" sz="1200" dirty="0">
                <a:latin typeface="Arial"/>
                <a:ea typeface="Arial" charset="0"/>
                <a:cs typeface="Arial"/>
              </a:endParaRPr>
            </a:p>
          </p:txBody>
        </p:sp>
        <p:cxnSp>
          <p:nvCxnSpPr>
            <p:cNvPr id="318" name="直線矢印コネクタ 317"/>
            <p:cNvCxnSpPr/>
            <p:nvPr/>
          </p:nvCxnSpPr>
          <p:spPr bwMode="auto">
            <a:xfrm>
              <a:off x="1916832" y="2339752"/>
              <a:ext cx="100811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9" name="Rectangle 18"/>
            <p:cNvSpPr>
              <a:spLocks noChangeArrowheads="1"/>
            </p:cNvSpPr>
            <p:nvPr/>
          </p:nvSpPr>
          <p:spPr bwMode="auto">
            <a:xfrm>
              <a:off x="4005064" y="2267744"/>
              <a:ext cx="320776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900" dirty="0" smtClean="0">
                  <a:solidFill>
                    <a:srgbClr val="000000"/>
                  </a:solidFill>
                  <a:latin typeface="Arial"/>
                  <a:ea typeface="Arial" charset="0"/>
                  <a:cs typeface="Arial"/>
                </a:rPr>
                <a:t>Foxp3</a:t>
              </a:r>
              <a:endParaRPr lang="en-US" altLang="ja-JP" sz="1200" dirty="0">
                <a:latin typeface="Arial"/>
                <a:ea typeface="Arial" charset="0"/>
                <a:cs typeface="Arial"/>
              </a:endParaRPr>
            </a:p>
          </p:txBody>
        </p:sp>
        <p:cxnSp>
          <p:nvCxnSpPr>
            <p:cNvPr id="320" name="直線矢印コネクタ 319"/>
            <p:cNvCxnSpPr/>
            <p:nvPr/>
          </p:nvCxnSpPr>
          <p:spPr bwMode="auto">
            <a:xfrm>
              <a:off x="4365104" y="2339752"/>
              <a:ext cx="100811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テキスト ボックス 4"/>
            <p:cNvSpPr txBox="1"/>
            <p:nvPr/>
          </p:nvSpPr>
          <p:spPr>
            <a:xfrm>
              <a:off x="1484784" y="349950"/>
              <a:ext cx="1800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>
                  <a:latin typeface="Arial"/>
                  <a:ea typeface="ＭＳ 明朝"/>
                  <a:cs typeface="Arial"/>
                </a:rPr>
                <a:t>CD4</a:t>
              </a:r>
              <a:r>
                <a:rPr lang="en-US" altLang="ja-JP" sz="1100" baseline="30000" dirty="0">
                  <a:latin typeface="Arial"/>
                  <a:ea typeface="ＭＳ 明朝"/>
                  <a:cs typeface="Arial"/>
                </a:rPr>
                <a:t>+</a:t>
              </a:r>
              <a:r>
                <a:rPr lang="en-US" altLang="ja-JP" sz="1100" dirty="0">
                  <a:latin typeface="Arial"/>
                  <a:ea typeface="ＭＳ 明朝"/>
                  <a:cs typeface="Arial"/>
                </a:rPr>
                <a:t>CD25</a:t>
              </a:r>
              <a:r>
                <a:rPr lang="en-US" altLang="ja-JP" sz="1100" baseline="30000" dirty="0">
                  <a:latin typeface="Arial"/>
                  <a:ea typeface="ＭＳ 明朝"/>
                  <a:cs typeface="Arial"/>
                </a:rPr>
                <a:t>+</a:t>
              </a:r>
              <a:r>
                <a:rPr lang="en-US" altLang="ja-JP" sz="1100" dirty="0">
                  <a:latin typeface="Arial"/>
                  <a:ea typeface="ＭＳ 明朝"/>
                  <a:cs typeface="Arial"/>
                </a:rPr>
                <a:t>GITR</a:t>
              </a:r>
              <a:r>
                <a:rPr lang="en-US" altLang="ja-JP" sz="1100" baseline="30000" dirty="0">
                  <a:latin typeface="Arial"/>
                  <a:ea typeface="ＭＳ 明朝"/>
                  <a:cs typeface="Arial"/>
                </a:rPr>
                <a:t>high</a:t>
              </a:r>
              <a:r>
                <a:rPr lang="en-US" altLang="ja-JP" sz="1100" dirty="0">
                  <a:latin typeface="Arial"/>
                  <a:ea typeface="ＭＳ 明朝"/>
                  <a:cs typeface="Arial"/>
                </a:rPr>
                <a:t> cells</a:t>
              </a:r>
              <a:endParaRPr kumimoji="1" lang="ja-JP" altLang="en-US" sz="1100" dirty="0"/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3933056" y="349950"/>
              <a:ext cx="1800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>
                  <a:latin typeface="Arial"/>
                  <a:ea typeface="ＭＳ 明朝"/>
                  <a:cs typeface="Arial"/>
                </a:rPr>
                <a:t>CD4</a:t>
              </a:r>
              <a:r>
                <a:rPr lang="en-US" altLang="ja-JP" sz="1100" baseline="30000" dirty="0">
                  <a:latin typeface="Arial"/>
                  <a:ea typeface="ＭＳ 明朝"/>
                  <a:cs typeface="Arial"/>
                </a:rPr>
                <a:t>+</a:t>
              </a:r>
              <a:r>
                <a:rPr lang="en-US" altLang="ja-JP" sz="1100" dirty="0">
                  <a:latin typeface="Arial"/>
                  <a:ea typeface="ＭＳ 明朝"/>
                  <a:cs typeface="Arial"/>
                </a:rPr>
                <a:t>CD25</a:t>
              </a:r>
              <a:r>
                <a:rPr lang="en-US" altLang="ja-JP" sz="1100" baseline="30000" dirty="0">
                  <a:latin typeface="Arial"/>
                  <a:ea typeface="ＭＳ 明朝"/>
                  <a:cs typeface="Arial"/>
                </a:rPr>
                <a:t>-</a:t>
              </a:r>
              <a:r>
                <a:rPr lang="en-US" altLang="ja-JP" sz="1100" dirty="0">
                  <a:latin typeface="Arial"/>
                  <a:ea typeface="ＭＳ 明朝"/>
                  <a:cs typeface="Arial"/>
                </a:rPr>
                <a:t>GITR</a:t>
              </a:r>
              <a:r>
                <a:rPr lang="en-US" altLang="ja-JP" sz="1100" baseline="30000" dirty="0">
                  <a:latin typeface="Arial"/>
                  <a:ea typeface="ＭＳ 明朝"/>
                  <a:cs typeface="Arial"/>
                </a:rPr>
                <a:t>low</a:t>
              </a:r>
              <a:r>
                <a:rPr lang="en-US" altLang="ja-JP" sz="1100" dirty="0">
                  <a:latin typeface="Arial"/>
                  <a:ea typeface="ＭＳ 明朝"/>
                  <a:cs typeface="Arial"/>
                </a:rPr>
                <a:t> cells </a:t>
              </a:r>
              <a:endParaRPr kumimoji="1" lang="ja-JP" altLang="en-US" sz="1100" dirty="0"/>
            </a:p>
          </p:txBody>
        </p:sp>
      </p:grpSp>
      <p:sp>
        <p:nvSpPr>
          <p:cNvPr id="321" name="Rectangle 492"/>
          <p:cNvSpPr>
            <a:spLocks noChangeArrowheads="1"/>
          </p:cNvSpPr>
          <p:nvPr/>
        </p:nvSpPr>
        <p:spPr bwMode="auto">
          <a:xfrm>
            <a:off x="1340768" y="1763688"/>
            <a:ext cx="3029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Arial"/>
                <a:ea typeface="Arial" charset="0"/>
                <a:cs typeface="Arial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7273481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0</Words>
  <Application>Microsoft Macintosh PowerPoint</Application>
  <PresentationFormat>画面に合わせる 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Manager/>
  <Company>Kyoto University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Matsuoka Masao</dc:creator>
  <cp:keywords/>
  <dc:description/>
  <cp:lastModifiedBy>Matsuoka Masao</cp:lastModifiedBy>
  <cp:revision>4</cp:revision>
  <dcterms:created xsi:type="dcterms:W3CDTF">2013-08-16T07:54:25Z</dcterms:created>
  <dcterms:modified xsi:type="dcterms:W3CDTF">2013-08-16T07:56:58Z</dcterms:modified>
  <cp:category/>
</cp:coreProperties>
</file>